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7"/>
  </p:notesMasterIdLst>
  <p:sldIdLst>
    <p:sldId id="275" r:id="rId2"/>
    <p:sldId id="278" r:id="rId3"/>
    <p:sldId id="272" r:id="rId4"/>
    <p:sldId id="283" r:id="rId5"/>
    <p:sldId id="258" r:id="rId6"/>
    <p:sldId id="259" r:id="rId7"/>
    <p:sldId id="277" r:id="rId8"/>
    <p:sldId id="260" r:id="rId9"/>
    <p:sldId id="281" r:id="rId10"/>
    <p:sldId id="261" r:id="rId11"/>
    <p:sldId id="282" r:id="rId12"/>
    <p:sldId id="279" r:id="rId13"/>
    <p:sldId id="262" r:id="rId14"/>
    <p:sldId id="263" r:id="rId15"/>
    <p:sldId id="264" r:id="rId16"/>
    <p:sldId id="265" r:id="rId17"/>
    <p:sldId id="274" r:id="rId18"/>
    <p:sldId id="284" r:id="rId19"/>
    <p:sldId id="276" r:id="rId20"/>
    <p:sldId id="266" r:id="rId21"/>
    <p:sldId id="267" r:id="rId22"/>
    <p:sldId id="268" r:id="rId23"/>
    <p:sldId id="280" r:id="rId24"/>
    <p:sldId id="269" r:id="rId25"/>
    <p:sldId id="270" r:id="rId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97" autoAdjust="0"/>
    <p:restoredTop sz="94660"/>
  </p:normalViewPr>
  <p:slideViewPr>
    <p:cSldViewPr snapToGrid="0">
      <p:cViewPr>
        <p:scale>
          <a:sx n="60" d="100"/>
          <a:sy n="60" d="100"/>
        </p:scale>
        <p:origin x="118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notesMaster" Target="notesMasters/notesMaster1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977F35-930F-4FB5-ACA4-7A573ABF9AB9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301BA8-D559-414F-B4C1-128D2075A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108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301BA8-D559-414F-B4C1-128D2075A58A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4217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32A740-72A7-3638-EAB0-F17157604C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C07678-39E9-2F88-2683-DC766725FE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0F34A-1FAA-7D0A-2BD0-D6B566BE7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8AED67-4C2A-3E9F-A18A-E0EDE06EB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CF47F0-61DB-7406-4922-6ADF071F5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390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B25A6-0F65-2ED5-F9E8-3CFCA64CC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C0E597-D93F-3785-90CA-95F61B434D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E5EDD-85A0-1D9C-6C88-A5EABE5F5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673ACF-E8B9-D8A3-A619-66431C5A3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711207-1DD9-4058-3F9C-A724DA108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26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588DD7-20A8-690C-ECC2-D74E23A962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3D9C10-E325-2553-8458-45EB3BD6B2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E3570-22A8-01D0-1F9D-BB24AB044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3D611-294F-D86B-67C4-8AA039309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16002-9BBA-32BA-BEEC-9B8025F36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20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0F1B6-5FD4-022E-C344-F11807607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4A9CCE-A140-1C31-389A-CB66CBA66B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CB3B8B-70E4-BD25-03AC-1CF23F1E1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85D808-4423-EA8B-C2BB-5EB528EBD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43A0D-2736-2CB5-5C0A-F76062BE1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718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1CE9F-AE09-5243-27BB-1E5126968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8AA98-14B2-6474-BF35-C333ACEED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CD04E-7A42-E1A7-0BF8-6D0896E8E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571BE-88DB-CF3C-1CAE-D0122C85A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E3F2E2-34DF-CAA1-4452-A06699908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527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108F5-F53C-C984-D65B-2C494FE87D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9EBC38-C8C2-A35F-7BC1-CD1CED49E0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4A4ECF-0B5D-D978-76AF-446CE6D31E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F208DC-95EC-6F40-471B-B87A0AE75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15E0C4-A98D-08B0-18DC-8177C1D1F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84D575-D25A-92CB-D5F4-DDD458E6A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21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49B506-C1D6-78C7-971A-C9549FAE1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38CBDB-2BE2-BC3B-DEB5-6DBCC4A889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6BA177-C98E-A055-1438-67A21C31FE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2C00B0-0638-DC41-06A9-002C2D0F96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407DBA-CC76-39C5-FAB7-BB540D8A90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F2BC44-D038-43AC-BE58-169FD675F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9BD972-8469-444A-FFF0-B622ECF89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8F9A60-6F98-E14E-BA70-145B6AF7D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768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60E27-07CF-1319-55F9-CFCB5884A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F29CF2-A924-A9C0-B6CA-05E46D78F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76247C-F26F-356B-50FF-15F89ACF4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AE45AB-56DF-11A7-AF83-32D69AF0B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790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F80408-6F68-5CA0-408C-8422E388C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FC37A0-94F3-9CEE-9128-F5D8AB63C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45BC88-F56E-0C1C-220A-32047AC17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492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A4FBD0-61BA-A648-8A38-48854CD51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46C989-E02B-CD43-EFEF-3D076E290A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3F1510-9BFB-6735-312A-1612E0151F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8C8EC2-783B-9AEE-315C-E503FE482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FFF886-DDE1-C571-2ED2-99BF62F2E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7A8F8E-4B4B-CB71-ACB4-576CBE9CE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785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56E45-A970-A80E-4F69-39CAA7F44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AAE870-511F-D7A7-0A9F-443C6FBC40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565E18-A709-D979-A8D7-95DEAE1B31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0310E9-70DA-6F51-69FA-EFBBA91BB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61F1C1-E354-4566-105E-6926A64AC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BA78A-FF96-4E6A-C7BE-3C7ED63C5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365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6CCD1A-8DEE-12B5-8A53-518E6C3767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FC1740-7D9D-DDDA-C1C5-966572BA22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A3806E-C301-9ECD-3AC0-F12AD927FF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8BA139-22D2-4B8F-99D6-AC9D1A07D6F1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E6E72-0D35-E8AF-07CB-2B0777BB5F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0C151F-8FBC-57F7-0250-5F88E49517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2718EF-64A7-4048-A7AE-3DC5C5AA30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893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8E21A9F-1A62-908F-24C2-B800F20222B6}"/>
              </a:ext>
            </a:extLst>
          </p:cNvPr>
          <p:cNvSpPr/>
          <p:nvPr/>
        </p:nvSpPr>
        <p:spPr>
          <a:xfrm>
            <a:off x="2969925" y="0"/>
            <a:ext cx="6698730" cy="95937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spcBef>
                <a:spcPct val="0"/>
              </a:spcBef>
              <a:spcAft>
                <a:spcPts val="600"/>
              </a:spcAft>
            </a:pPr>
            <a:r>
              <a:rPr lang="en-US" sz="28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5</a:t>
            </a:r>
          </a:p>
          <a:p>
            <a:pPr algn="ctr">
              <a:spcBef>
                <a:spcPct val="0"/>
              </a:spcBef>
              <a:spcAft>
                <a:spcPts val="600"/>
              </a:spcAft>
            </a:pPr>
            <a:r>
              <a:rPr lang="en-US" sz="28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Drugs docking human IL-6R (1n26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346E20-F215-B4DE-A839-5E6E94594271}"/>
              </a:ext>
            </a:extLst>
          </p:cNvPr>
          <p:cNvSpPr txBox="1"/>
          <p:nvPr/>
        </p:nvSpPr>
        <p:spPr>
          <a:xfrm>
            <a:off x="239842" y="959371"/>
            <a:ext cx="11712315" cy="61247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corbate, methionine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Zinc oxide did not dock IL-6R. Phytic, Aminopterin, Candesartan, remdesivir, Dexamethasone, I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dirubin,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mpferol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alcitriol, Quercetin, 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igenin and Ferulic had high affinity towards IL-6R with the lowest binding energy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22.57, -118.9, -117.3, -101.28, 98.31, 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91.96, -91.43, -85.67, -84.21, 81.94, -81.68 and -60.6 Kcal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ol, respectively. Ferulic, kaempferol and quercetin targeted (Cys77, Cys258) and (Cys258), respectively, (red arrow). Acacetin,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mpferol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hytic, Quercetin and Quinapril bind to many residues especially, (His256), (Trp249, Met250, Val251, Lys252, Gln255), (Asp253, Gln255, Hi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6, His257), (Trp249, Met250, Val251, Lys252, Gln255), (Met250 Val251, Lys252, His261) (black arrow), respectively.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the only small molecule compound can target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n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idue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sn136, green arrow)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dditionally, all of the studied small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dules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n target B-cell epitopes of IL-6R (coloured asterisk).</a:t>
            </a:r>
            <a:endParaRPr lang="en-GB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306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30B71D0-8053-9DE5-686D-B83EE393A8BC}"/>
              </a:ext>
            </a:extLst>
          </p:cNvPr>
          <p:cNvSpPr/>
          <p:nvPr/>
        </p:nvSpPr>
        <p:spPr>
          <a:xfrm>
            <a:off x="3404017" y="6181642"/>
            <a:ext cx="878798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h: Coumarin docked human IL-6R (1n26)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9D9A78B-DC55-41BF-7609-9A6DEDE86F53}"/>
              </a:ext>
            </a:extLst>
          </p:cNvPr>
          <p:cNvGrpSpPr/>
          <p:nvPr/>
        </p:nvGrpSpPr>
        <p:grpSpPr>
          <a:xfrm>
            <a:off x="3909039" y="463703"/>
            <a:ext cx="7883647" cy="5717939"/>
            <a:chOff x="818413" y="674467"/>
            <a:chExt cx="10555173" cy="5417142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E637EB4A-A50E-6009-B54A-0A762B8C4AE6}"/>
                </a:ext>
              </a:extLst>
            </p:cNvPr>
            <p:cNvGrpSpPr/>
            <p:nvPr/>
          </p:nvGrpSpPr>
          <p:grpSpPr>
            <a:xfrm>
              <a:off x="818413" y="766391"/>
              <a:ext cx="10555173" cy="5325218"/>
              <a:chOff x="818413" y="766391"/>
              <a:chExt cx="10555173" cy="5325218"/>
            </a:xfrm>
          </p:grpSpPr>
          <p:pic>
            <p:nvPicPr>
              <p:cNvPr id="4" name="Picture 3" descr="A close-up of a diagram&#10;&#10;Description automatically generated">
                <a:extLst>
                  <a:ext uri="{FF2B5EF4-FFF2-40B4-BE49-F238E27FC236}">
                    <a16:creationId xmlns:a16="http://schemas.microsoft.com/office/drawing/2014/main" id="{0CD122D4-587D-795B-8663-E3D1CB0C4C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8413" y="766391"/>
                <a:ext cx="10555173" cy="5325218"/>
              </a:xfrm>
              <a:prstGeom prst="rect">
                <a:avLst/>
              </a:prstGeom>
            </p:spPr>
          </p:pic>
          <p:sp>
            <p:nvSpPr>
              <p:cNvPr id="3" name="Star: 5 Points 2">
                <a:extLst>
                  <a:ext uri="{FF2B5EF4-FFF2-40B4-BE49-F238E27FC236}">
                    <a16:creationId xmlns:a16="http://schemas.microsoft.com/office/drawing/2014/main" id="{10570A0D-04D8-D771-BF48-9B7E481C9303}"/>
                  </a:ext>
                </a:extLst>
              </p:cNvPr>
              <p:cNvSpPr/>
              <p:nvPr/>
            </p:nvSpPr>
            <p:spPr>
              <a:xfrm>
                <a:off x="8074856" y="1645920"/>
                <a:ext cx="239150" cy="267287"/>
              </a:xfrm>
              <a:prstGeom prst="star5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Star: 5 Points 5">
                <a:extLst>
                  <a:ext uri="{FF2B5EF4-FFF2-40B4-BE49-F238E27FC236}">
                    <a16:creationId xmlns:a16="http://schemas.microsoft.com/office/drawing/2014/main" id="{36D992CF-FA8C-FCB4-1395-CBC21EEBAD02}"/>
                  </a:ext>
                </a:extLst>
              </p:cNvPr>
              <p:cNvSpPr/>
              <p:nvPr/>
            </p:nvSpPr>
            <p:spPr>
              <a:xfrm>
                <a:off x="9868486" y="1249679"/>
                <a:ext cx="239150" cy="267287"/>
              </a:xfrm>
              <a:prstGeom prst="star5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Star: 5 Points 6">
                <a:extLst>
                  <a:ext uri="{FF2B5EF4-FFF2-40B4-BE49-F238E27FC236}">
                    <a16:creationId xmlns:a16="http://schemas.microsoft.com/office/drawing/2014/main" id="{25D1361E-E495-C03D-861C-053DFE75D9FD}"/>
                  </a:ext>
                </a:extLst>
              </p:cNvPr>
              <p:cNvSpPr/>
              <p:nvPr/>
            </p:nvSpPr>
            <p:spPr>
              <a:xfrm>
                <a:off x="8972923" y="3924885"/>
                <a:ext cx="239150" cy="267287"/>
              </a:xfrm>
              <a:prstGeom prst="star5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Star: 5 Points 7">
                <a:extLst>
                  <a:ext uri="{FF2B5EF4-FFF2-40B4-BE49-F238E27FC236}">
                    <a16:creationId xmlns:a16="http://schemas.microsoft.com/office/drawing/2014/main" id="{8A0D6C08-6FD8-5043-7970-5D3608E803F0}"/>
                  </a:ext>
                </a:extLst>
              </p:cNvPr>
              <p:cNvSpPr/>
              <p:nvPr/>
            </p:nvSpPr>
            <p:spPr>
              <a:xfrm>
                <a:off x="11066711" y="3974122"/>
                <a:ext cx="158600" cy="168812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Star: 5 Points 1">
                <a:extLst>
                  <a:ext uri="{FF2B5EF4-FFF2-40B4-BE49-F238E27FC236}">
                    <a16:creationId xmlns:a16="http://schemas.microsoft.com/office/drawing/2014/main" id="{91B27D94-FAE4-634D-8A6E-CCF3362C3809}"/>
                  </a:ext>
                </a:extLst>
              </p:cNvPr>
              <p:cNvSpPr/>
              <p:nvPr/>
            </p:nvSpPr>
            <p:spPr>
              <a:xfrm>
                <a:off x="10107636" y="3884797"/>
                <a:ext cx="162781" cy="208629"/>
              </a:xfrm>
              <a:prstGeom prst="star5">
                <a:avLst/>
              </a:prstGeom>
              <a:solidFill>
                <a:srgbClr val="FF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Star: 5 Points 9">
                <a:extLst>
                  <a:ext uri="{FF2B5EF4-FFF2-40B4-BE49-F238E27FC236}">
                    <a16:creationId xmlns:a16="http://schemas.microsoft.com/office/drawing/2014/main" id="{ECCF25C1-AF28-0F81-4BF4-06C876898770}"/>
                  </a:ext>
                </a:extLst>
              </p:cNvPr>
              <p:cNvSpPr/>
              <p:nvPr/>
            </p:nvSpPr>
            <p:spPr>
              <a:xfrm>
                <a:off x="8879099" y="1607244"/>
                <a:ext cx="239150" cy="267287"/>
              </a:xfrm>
              <a:prstGeom prst="star5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Star: 5 Points 10">
                <a:extLst>
                  <a:ext uri="{FF2B5EF4-FFF2-40B4-BE49-F238E27FC236}">
                    <a16:creationId xmlns:a16="http://schemas.microsoft.com/office/drawing/2014/main" id="{2189200C-5EB5-46D2-DEB7-2355E0FE093A}"/>
                  </a:ext>
                </a:extLst>
              </p:cNvPr>
              <p:cNvSpPr/>
              <p:nvPr/>
            </p:nvSpPr>
            <p:spPr>
              <a:xfrm>
                <a:off x="8124092" y="3791241"/>
                <a:ext cx="239150" cy="267287"/>
              </a:xfrm>
              <a:prstGeom prst="star5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Star: 5 Points 11">
                <a:extLst>
                  <a:ext uri="{FF2B5EF4-FFF2-40B4-BE49-F238E27FC236}">
                    <a16:creationId xmlns:a16="http://schemas.microsoft.com/office/drawing/2014/main" id="{7D25A5FA-52F7-E608-6430-775A7529F9ED}"/>
                  </a:ext>
                </a:extLst>
              </p:cNvPr>
              <p:cNvSpPr/>
              <p:nvPr/>
            </p:nvSpPr>
            <p:spPr>
              <a:xfrm>
                <a:off x="10700207" y="3324685"/>
                <a:ext cx="162781" cy="208629"/>
              </a:xfrm>
              <a:prstGeom prst="star5">
                <a:avLst/>
              </a:prstGeom>
              <a:solidFill>
                <a:srgbClr val="FF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4DF44EDB-99CD-D5D9-8821-70568B1149C8}"/>
                </a:ext>
              </a:extLst>
            </p:cNvPr>
            <p:cNvSpPr/>
            <p:nvPr/>
          </p:nvSpPr>
          <p:spPr>
            <a:xfrm>
              <a:off x="8879099" y="674467"/>
              <a:ext cx="239150" cy="26728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B38C1967-982E-435F-90E3-519ED650073A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7" name="Picture 16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9F33DBCC-864F-154B-196E-6171C2D498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2A110946-F2CD-57A9-8DF2-73AF01BAC425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92053CB8-4CA7-03E9-C0BB-57A5C7DF8EC4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D1F3AE65-62FB-6DC1-67E0-E691ACA0F521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1A9F5ED8-881C-FEF7-4F00-2B85794D14A1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AF489336-9E8D-1B78-92B3-C153313295B1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B701A6F8-FB40-6057-4D4E-A9EE3D49F7B9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DB17BB7E-E94C-6CFC-C36C-6DC5AE2431F3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2787376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971D0C7-B460-33BA-49E7-7AA701A459B5}"/>
              </a:ext>
            </a:extLst>
          </p:cNvPr>
          <p:cNvSpPr/>
          <p:nvPr/>
        </p:nvSpPr>
        <p:spPr>
          <a:xfrm>
            <a:off x="2003282" y="6126800"/>
            <a:ext cx="977863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i: Dexamethasone docked human IL-6R (1n26)</a:t>
            </a:r>
          </a:p>
        </p:txBody>
      </p:sp>
      <p:pic>
        <p:nvPicPr>
          <p:cNvPr id="20" name="Picture 19" descr="A diagram of a structure&#10;&#10;AI-generated content may be incorrect.">
            <a:extLst>
              <a:ext uri="{FF2B5EF4-FFF2-40B4-BE49-F238E27FC236}">
                <a16:creationId xmlns:a16="http://schemas.microsoft.com/office/drawing/2014/main" id="{20E6282E-D0E5-85C9-A9CA-8F9BC9E95D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9745" y="899927"/>
            <a:ext cx="10401300" cy="5276850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8CADA0FF-89D0-2C78-A82C-9AFC913B366A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22" name="Picture 21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FFAAE1FD-32AD-3274-DA50-88C9C9C9D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156EF9C5-EFE1-6E6A-A4D3-FFE1B40EB420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9A66EC4F-9F96-24A8-F8CF-B779044F1212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A03CFCFE-D967-5F6E-11E6-A829A12176DC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8F1E9533-9CA4-93E0-D7B3-F8B979FA21BA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40EDD622-51B0-F6B8-FB77-E8C4FD4E14F7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tar: 5 Points 27">
              <a:extLst>
                <a:ext uri="{FF2B5EF4-FFF2-40B4-BE49-F238E27FC236}">
                  <a16:creationId xmlns:a16="http://schemas.microsoft.com/office/drawing/2014/main" id="{146ECA36-87D7-5811-76EA-F70EA3A0597C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tar: 5 Points 28">
              <a:extLst>
                <a:ext uri="{FF2B5EF4-FFF2-40B4-BE49-F238E27FC236}">
                  <a16:creationId xmlns:a16="http://schemas.microsoft.com/office/drawing/2014/main" id="{015D201C-3E19-1A7D-1700-8EC597E34AD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30" name="Star: 5 Points 29">
            <a:extLst>
              <a:ext uri="{FF2B5EF4-FFF2-40B4-BE49-F238E27FC236}">
                <a16:creationId xmlns:a16="http://schemas.microsoft.com/office/drawing/2014/main" id="{5D196FA4-DC73-BF51-CD70-B39731850A38}"/>
              </a:ext>
            </a:extLst>
          </p:cNvPr>
          <p:cNvSpPr/>
          <p:nvPr/>
        </p:nvSpPr>
        <p:spPr>
          <a:xfrm>
            <a:off x="8783145" y="1694611"/>
            <a:ext cx="77995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Star: 5 Points 30">
            <a:extLst>
              <a:ext uri="{FF2B5EF4-FFF2-40B4-BE49-F238E27FC236}">
                <a16:creationId xmlns:a16="http://schemas.microsoft.com/office/drawing/2014/main" id="{2F8B3C15-9088-88BD-BBCA-F9834898070D}"/>
              </a:ext>
            </a:extLst>
          </p:cNvPr>
          <p:cNvSpPr/>
          <p:nvPr/>
        </p:nvSpPr>
        <p:spPr>
          <a:xfrm>
            <a:off x="7682025" y="2151811"/>
            <a:ext cx="77995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Star: 5 Points 31">
            <a:extLst>
              <a:ext uri="{FF2B5EF4-FFF2-40B4-BE49-F238E27FC236}">
                <a16:creationId xmlns:a16="http://schemas.microsoft.com/office/drawing/2014/main" id="{97AC8852-A3C0-9A06-3403-2708ED10EAFA}"/>
              </a:ext>
            </a:extLst>
          </p:cNvPr>
          <p:cNvSpPr/>
          <p:nvPr/>
        </p:nvSpPr>
        <p:spPr>
          <a:xfrm>
            <a:off x="7955243" y="2707864"/>
            <a:ext cx="77995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Star: 5 Points 32">
            <a:extLst>
              <a:ext uri="{FF2B5EF4-FFF2-40B4-BE49-F238E27FC236}">
                <a16:creationId xmlns:a16="http://schemas.microsoft.com/office/drawing/2014/main" id="{DF34549F-251E-292E-96E7-8D8394F6F07C}"/>
              </a:ext>
            </a:extLst>
          </p:cNvPr>
          <p:cNvSpPr/>
          <p:nvPr/>
        </p:nvSpPr>
        <p:spPr>
          <a:xfrm>
            <a:off x="10929636" y="3891854"/>
            <a:ext cx="65089" cy="5349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Star: 5 Points 33">
            <a:extLst>
              <a:ext uri="{FF2B5EF4-FFF2-40B4-BE49-F238E27FC236}">
                <a16:creationId xmlns:a16="http://schemas.microsoft.com/office/drawing/2014/main" id="{25724418-6E14-4F0A-2FCF-4580ADF883AD}"/>
              </a:ext>
            </a:extLst>
          </p:cNvPr>
          <p:cNvSpPr/>
          <p:nvPr/>
        </p:nvSpPr>
        <p:spPr>
          <a:xfrm>
            <a:off x="10352987" y="4031923"/>
            <a:ext cx="65089" cy="5349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Star: 5 Points 34">
            <a:extLst>
              <a:ext uri="{FF2B5EF4-FFF2-40B4-BE49-F238E27FC236}">
                <a16:creationId xmlns:a16="http://schemas.microsoft.com/office/drawing/2014/main" id="{117788B2-E85B-B6A6-B63C-FF3DD28FF768}"/>
              </a:ext>
            </a:extLst>
          </p:cNvPr>
          <p:cNvSpPr/>
          <p:nvPr/>
        </p:nvSpPr>
        <p:spPr>
          <a:xfrm>
            <a:off x="11547474" y="3459870"/>
            <a:ext cx="65089" cy="5349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02209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B95E255-4753-0321-2373-6729E5759B58}"/>
              </a:ext>
            </a:extLst>
          </p:cNvPr>
          <p:cNvGrpSpPr/>
          <p:nvPr/>
        </p:nvGrpSpPr>
        <p:grpSpPr>
          <a:xfrm>
            <a:off x="639108" y="249196"/>
            <a:ext cx="1318769" cy="406331"/>
            <a:chOff x="3269207" y="859923"/>
            <a:chExt cx="4701794" cy="1190290"/>
          </a:xfrm>
        </p:grpSpPr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BECB44CD-07C4-57F2-7304-C6471561D03E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63027048-ED16-A325-16A7-6DB3E9EA83C1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30FD1142-DEAA-0F73-D703-E71EC880FCEC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11E3886B-3821-F688-7D5D-85EADCABFC2A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67AA774D-516E-C906-1C2F-F644C0F45A0D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1EF83379-EC29-9B56-E247-2883EA2B6AE8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B55C0A7F-764B-5300-D032-0F033DD60BEA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3" name="Picture 12" descr="A close-up of a dna structure&#10;&#10;AI-generated content may be incorrect.">
            <a:extLst>
              <a:ext uri="{FF2B5EF4-FFF2-40B4-BE49-F238E27FC236}">
                <a16:creationId xmlns:a16="http://schemas.microsoft.com/office/drawing/2014/main" id="{BA98F363-2854-EEFE-0D4A-E348D68DFA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3773" y="857615"/>
            <a:ext cx="9493738" cy="5283472"/>
          </a:xfrm>
          <a:prstGeom prst="rect">
            <a:avLst/>
          </a:prstGeom>
        </p:spPr>
      </p:pic>
      <p:pic>
        <p:nvPicPr>
          <p:cNvPr id="14" name="Picture 13" descr="A graph with green and yellow lines&#10;&#10;AI-generated content may be incorrect.">
            <a:extLst>
              <a:ext uri="{FF2B5EF4-FFF2-40B4-BE49-F238E27FC236}">
                <a16:creationId xmlns:a16="http://schemas.microsoft.com/office/drawing/2014/main" id="{7074ED5E-D14A-ED1B-6F9A-53DEDC3A84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768"/>
            <a:ext cx="2891481" cy="1895019"/>
          </a:xfrm>
          <a:prstGeom prst="rect">
            <a:avLst/>
          </a:prstGeom>
        </p:spPr>
      </p:pic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BD166A6E-0970-A58C-4EC0-22B4FED7F866}"/>
              </a:ext>
            </a:extLst>
          </p:cNvPr>
          <p:cNvSpPr/>
          <p:nvPr/>
        </p:nvSpPr>
        <p:spPr>
          <a:xfrm>
            <a:off x="8896749" y="1757935"/>
            <a:ext cx="121581" cy="220214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591E81ED-F7AE-AC29-2702-86EF9F263315}"/>
              </a:ext>
            </a:extLst>
          </p:cNvPr>
          <p:cNvSpPr/>
          <p:nvPr/>
        </p:nvSpPr>
        <p:spPr>
          <a:xfrm>
            <a:off x="8041983" y="2647128"/>
            <a:ext cx="121581" cy="220214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8213D8C9-A56D-4970-321F-CAC05B7F3BD1}"/>
              </a:ext>
            </a:extLst>
          </p:cNvPr>
          <p:cNvSpPr/>
          <p:nvPr/>
        </p:nvSpPr>
        <p:spPr>
          <a:xfrm>
            <a:off x="9422371" y="1450558"/>
            <a:ext cx="178621" cy="282129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CF337CB6-30EF-68D8-7149-53EA1EE7807A}"/>
              </a:ext>
            </a:extLst>
          </p:cNvPr>
          <p:cNvSpPr/>
          <p:nvPr/>
        </p:nvSpPr>
        <p:spPr>
          <a:xfrm>
            <a:off x="9767606" y="2146948"/>
            <a:ext cx="178621" cy="282129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D61F4B54-25FB-DD19-03DA-0BC498AAD377}"/>
              </a:ext>
            </a:extLst>
          </p:cNvPr>
          <p:cNvSpPr/>
          <p:nvPr/>
        </p:nvSpPr>
        <p:spPr>
          <a:xfrm>
            <a:off x="9333060" y="4376598"/>
            <a:ext cx="178621" cy="282129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C216A5F1-D4A7-31EE-079D-839AFFEA9DA8}"/>
              </a:ext>
            </a:extLst>
          </p:cNvPr>
          <p:cNvSpPr/>
          <p:nvPr/>
        </p:nvSpPr>
        <p:spPr>
          <a:xfrm>
            <a:off x="8318280" y="1921830"/>
            <a:ext cx="178621" cy="282129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9A3C766F-DA77-11B2-065D-F0119FD13F06}"/>
              </a:ext>
            </a:extLst>
          </p:cNvPr>
          <p:cNvSpPr/>
          <p:nvPr/>
        </p:nvSpPr>
        <p:spPr>
          <a:xfrm>
            <a:off x="8718128" y="4401930"/>
            <a:ext cx="178621" cy="282129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A4C4399-F0C9-ECBB-073A-D426182BE4BD}"/>
              </a:ext>
            </a:extLst>
          </p:cNvPr>
          <p:cNvSpPr/>
          <p:nvPr/>
        </p:nvSpPr>
        <p:spPr>
          <a:xfrm>
            <a:off x="3338873" y="6183603"/>
            <a:ext cx="870623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j: Enalapril docked human IL-6R (1n26)</a:t>
            </a:r>
          </a:p>
        </p:txBody>
      </p:sp>
    </p:spTree>
    <p:extLst>
      <p:ext uri="{BB962C8B-B14F-4D97-AF65-F5344CB8AC3E}">
        <p14:creationId xmlns:p14="http://schemas.microsoft.com/office/powerpoint/2010/main" val="6273464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DF8D7F29-ECD8-8A58-7E1A-B11845E94DA7}"/>
              </a:ext>
            </a:extLst>
          </p:cNvPr>
          <p:cNvGrpSpPr/>
          <p:nvPr/>
        </p:nvGrpSpPr>
        <p:grpSpPr>
          <a:xfrm>
            <a:off x="3896139" y="631956"/>
            <a:ext cx="8008646" cy="5454890"/>
            <a:chOff x="851755" y="771154"/>
            <a:chExt cx="10488489" cy="5315692"/>
          </a:xfrm>
        </p:grpSpPr>
        <p:pic>
          <p:nvPicPr>
            <p:cNvPr id="4" name="Picture 3" descr="A close-up of a diagram&#10;&#10;Description automatically generated">
              <a:extLst>
                <a:ext uri="{FF2B5EF4-FFF2-40B4-BE49-F238E27FC236}">
                  <a16:creationId xmlns:a16="http://schemas.microsoft.com/office/drawing/2014/main" id="{2C9CA18C-4636-F93A-3806-1141566685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755" y="771154"/>
              <a:ext cx="10488489" cy="5315692"/>
            </a:xfrm>
            <a:prstGeom prst="rect">
              <a:avLst/>
            </a:prstGeom>
          </p:spPr>
        </p:pic>
        <p:sp>
          <p:nvSpPr>
            <p:cNvPr id="3" name="Arrow: Right 2">
              <a:extLst>
                <a:ext uri="{FF2B5EF4-FFF2-40B4-BE49-F238E27FC236}">
                  <a16:creationId xmlns:a16="http://schemas.microsoft.com/office/drawing/2014/main" id="{D692E1C6-AB61-A40B-A43E-02C875547C12}"/>
                </a:ext>
              </a:extLst>
            </p:cNvPr>
            <p:cNvSpPr/>
            <p:nvPr/>
          </p:nvSpPr>
          <p:spPr>
            <a:xfrm rot="19190021">
              <a:off x="7666983" y="4310057"/>
              <a:ext cx="399426" cy="329784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7CE4B9B8-61EE-F489-9A11-7E29CFA5E451}"/>
              </a:ext>
            </a:extLst>
          </p:cNvPr>
          <p:cNvSpPr/>
          <p:nvPr/>
        </p:nvSpPr>
        <p:spPr>
          <a:xfrm>
            <a:off x="3896139" y="6273225"/>
            <a:ext cx="829586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k: Ferulic docked human IL-6R (1n26)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B506DC6-3F96-46A3-9D10-6FA6CAC998A8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8" name="Picture 7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9972680-5EA7-B902-A5C5-4A2FCDD94AD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10CC7A81-5088-D232-C210-D33CA8C4046B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64C77308-74E8-6ABC-0D92-72B25B339D13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A5A66ED8-79FE-F7CC-1526-686490954C0B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358339DB-5A04-A084-966B-550682E19F2F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44FCC701-4C4B-9273-1147-022367648B38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A077AEEB-4542-00FA-4167-0C5E4560372E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304115F9-227A-E3E1-B22D-1A14F2087DA8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431531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DE67AEA6-D032-A461-0678-031D1D55DCE2}"/>
              </a:ext>
            </a:extLst>
          </p:cNvPr>
          <p:cNvSpPr/>
          <p:nvPr/>
        </p:nvSpPr>
        <p:spPr>
          <a:xfrm>
            <a:off x="3468695" y="6119924"/>
            <a:ext cx="872867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l: Indirubin docked human IL-6R (1n26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E43C4AB-13E3-BF5D-F65C-157DEFC49190}"/>
              </a:ext>
            </a:extLst>
          </p:cNvPr>
          <p:cNvGrpSpPr/>
          <p:nvPr/>
        </p:nvGrpSpPr>
        <p:grpSpPr>
          <a:xfrm>
            <a:off x="3909039" y="86459"/>
            <a:ext cx="8175014" cy="5873261"/>
            <a:chOff x="851755" y="766391"/>
            <a:chExt cx="10488489" cy="5325218"/>
          </a:xfrm>
        </p:grpSpPr>
        <p:pic>
          <p:nvPicPr>
            <p:cNvPr id="4" name="Picture 3" descr="A close-up of a dna model&#10;&#10;Description automatically generated">
              <a:extLst>
                <a:ext uri="{FF2B5EF4-FFF2-40B4-BE49-F238E27FC236}">
                  <a16:creationId xmlns:a16="http://schemas.microsoft.com/office/drawing/2014/main" id="{13A396AD-DED5-52FE-1CE4-2597BB82EB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1755" y="766391"/>
              <a:ext cx="10488489" cy="5325218"/>
            </a:xfrm>
            <a:prstGeom prst="rect">
              <a:avLst/>
            </a:prstGeom>
          </p:spPr>
        </p:pic>
        <p:sp>
          <p:nvSpPr>
            <p:cNvPr id="3" name="Star: 5 Points 2">
              <a:extLst>
                <a:ext uri="{FF2B5EF4-FFF2-40B4-BE49-F238E27FC236}">
                  <a16:creationId xmlns:a16="http://schemas.microsoft.com/office/drawing/2014/main" id="{FC7F024B-90B9-A367-59D4-3C4C0E98C8D0}"/>
                </a:ext>
              </a:extLst>
            </p:cNvPr>
            <p:cNvSpPr/>
            <p:nvPr/>
          </p:nvSpPr>
          <p:spPr>
            <a:xfrm>
              <a:off x="9453489" y="1266092"/>
              <a:ext cx="140677" cy="182880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14E31B8F-7EC2-3B41-AB41-A6D01EE960A4}"/>
                </a:ext>
              </a:extLst>
            </p:cNvPr>
            <p:cNvSpPr/>
            <p:nvPr/>
          </p:nvSpPr>
          <p:spPr>
            <a:xfrm>
              <a:off x="7369126" y="3429000"/>
              <a:ext cx="140677" cy="182880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1113BE4C-0AB9-395B-F79E-BF3C3B95A331}"/>
                </a:ext>
              </a:extLst>
            </p:cNvPr>
            <p:cNvSpPr/>
            <p:nvPr/>
          </p:nvSpPr>
          <p:spPr>
            <a:xfrm>
              <a:off x="10170942" y="2222696"/>
              <a:ext cx="140677" cy="182880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2E931C16-2A99-8A7A-BD72-02557C6E7198}"/>
                </a:ext>
              </a:extLst>
            </p:cNvPr>
            <p:cNvSpPr/>
            <p:nvPr/>
          </p:nvSpPr>
          <p:spPr>
            <a:xfrm>
              <a:off x="8074856" y="3742006"/>
              <a:ext cx="140677" cy="182880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F8F427F7-D50E-AB30-E8D6-9324AF36834D}"/>
                </a:ext>
              </a:extLst>
            </p:cNvPr>
            <p:cNvSpPr/>
            <p:nvPr/>
          </p:nvSpPr>
          <p:spPr>
            <a:xfrm>
              <a:off x="10757222" y="4406812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CF823040-3FDE-73E9-508A-18EF3BDD6B23}"/>
                </a:ext>
              </a:extLst>
            </p:cNvPr>
            <p:cNvSpPr/>
            <p:nvPr/>
          </p:nvSpPr>
          <p:spPr>
            <a:xfrm>
              <a:off x="7777165" y="1266092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E48C06B8-E9ED-A9C5-BADE-8B0C753B66C1}"/>
                </a:ext>
              </a:extLst>
            </p:cNvPr>
            <p:cNvSpPr/>
            <p:nvPr/>
          </p:nvSpPr>
          <p:spPr>
            <a:xfrm>
              <a:off x="10363957" y="3626870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BC4ABD8B-3C46-ED5B-2012-FE5934BE8F27}"/>
                </a:ext>
              </a:extLst>
            </p:cNvPr>
            <p:cNvSpPr/>
            <p:nvPr/>
          </p:nvSpPr>
          <p:spPr>
            <a:xfrm>
              <a:off x="10089551" y="1448972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B4E0E5D7-DEA0-DA91-3132-5062E58CAB49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4" name="Picture 13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961CB8A-02DE-8C9B-E90A-51C11F55E2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4E3EE46C-47B9-5042-3B78-DF000BDDFE48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93D391E1-8932-0F70-3D82-F138849D646E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70D17D47-08AE-0D62-802F-A67103AEA33F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0A78EDF0-DF0F-8007-6492-19A29D51ED6C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5D8E6228-94D4-8833-DF96-0AE55D487D47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E360E5D0-ECB2-DB29-A615-964CD276DCFB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0E0C116D-B8A6-9D9D-EA56-F6F1934CBCC0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0726826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04CC8F6-7999-D763-8551-8139BC1B180B}"/>
              </a:ext>
            </a:extLst>
          </p:cNvPr>
          <p:cNvSpPr/>
          <p:nvPr/>
        </p:nvSpPr>
        <p:spPr>
          <a:xfrm>
            <a:off x="3042172" y="6184172"/>
            <a:ext cx="895790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m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Isoquinon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6R (1n26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5E42CFF-444F-A7DB-3DFF-8A0BF5FC91C4}"/>
              </a:ext>
            </a:extLst>
          </p:cNvPr>
          <p:cNvGrpSpPr/>
          <p:nvPr/>
        </p:nvGrpSpPr>
        <p:grpSpPr>
          <a:xfrm>
            <a:off x="3774978" y="382403"/>
            <a:ext cx="8225096" cy="5832299"/>
            <a:chOff x="561202" y="766391"/>
            <a:chExt cx="11069595" cy="5325218"/>
          </a:xfrm>
        </p:grpSpPr>
        <p:pic>
          <p:nvPicPr>
            <p:cNvPr id="4" name="Picture 3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EA05B3ED-48E9-3B1B-4BCE-380FB92FA2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202" y="766391"/>
              <a:ext cx="11069595" cy="5325218"/>
            </a:xfrm>
            <a:prstGeom prst="rect">
              <a:avLst/>
            </a:prstGeom>
          </p:spPr>
        </p:pic>
        <p:sp>
          <p:nvSpPr>
            <p:cNvPr id="3" name="Star: 5 Points 2">
              <a:extLst>
                <a:ext uri="{FF2B5EF4-FFF2-40B4-BE49-F238E27FC236}">
                  <a16:creationId xmlns:a16="http://schemas.microsoft.com/office/drawing/2014/main" id="{2BEE800C-F1A3-D02B-F8BB-46AFEFB14E7A}"/>
                </a:ext>
              </a:extLst>
            </p:cNvPr>
            <p:cNvSpPr/>
            <p:nvPr/>
          </p:nvSpPr>
          <p:spPr>
            <a:xfrm>
              <a:off x="8721969" y="3530990"/>
              <a:ext cx="239150" cy="26728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6E597D9C-F65C-0402-EAB8-037A64B3F682}"/>
                </a:ext>
              </a:extLst>
            </p:cNvPr>
            <p:cNvSpPr/>
            <p:nvPr/>
          </p:nvSpPr>
          <p:spPr>
            <a:xfrm>
              <a:off x="7495736" y="1350497"/>
              <a:ext cx="239150" cy="26728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939DA996-F444-EB64-EDD1-6A0A2AB39849}"/>
                </a:ext>
              </a:extLst>
            </p:cNvPr>
            <p:cNvSpPr/>
            <p:nvPr/>
          </p:nvSpPr>
          <p:spPr>
            <a:xfrm>
              <a:off x="11057207" y="1828799"/>
              <a:ext cx="239150" cy="26728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39D26E03-8119-8C66-54CD-26E16FB1DFFD}"/>
                </a:ext>
              </a:extLst>
            </p:cNvPr>
            <p:cNvSpPr/>
            <p:nvPr/>
          </p:nvSpPr>
          <p:spPr>
            <a:xfrm>
              <a:off x="7734886" y="3077210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DD687816-2709-893B-7702-AAFADA743512}"/>
                </a:ext>
              </a:extLst>
            </p:cNvPr>
            <p:cNvSpPr/>
            <p:nvPr/>
          </p:nvSpPr>
          <p:spPr>
            <a:xfrm>
              <a:off x="6774681" y="2536270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9DBAC5DC-E1CA-6741-38CE-35FC62FDA232}"/>
                </a:ext>
              </a:extLst>
            </p:cNvPr>
            <p:cNvSpPr/>
            <p:nvPr/>
          </p:nvSpPr>
          <p:spPr>
            <a:xfrm>
              <a:off x="9785542" y="925171"/>
              <a:ext cx="239150" cy="26728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75609C75-7D20-F1EC-14CE-C8D354B2C00E}"/>
                </a:ext>
              </a:extLst>
            </p:cNvPr>
            <p:cNvSpPr/>
            <p:nvPr/>
          </p:nvSpPr>
          <p:spPr>
            <a:xfrm>
              <a:off x="9992562" y="4336934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4FBEFBF5-2D3E-2E15-BD37-AD59993132A7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6" name="Picture 1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59DE19DF-4F5F-EEE6-4274-D9C6EFA5B5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CAD0F570-43B8-5727-FBBB-09300BFE1DAA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ED3555AB-BEDF-78BD-6F85-A964253515E6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1C6E40CA-7516-FA33-43FD-3A83FBCA4DC6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7ED12873-7657-35D4-A836-CC55ADDBDE6C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970094F7-7AD4-901C-2218-8F8D1F88E0EF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B755F310-94D6-B734-50AA-C390CAD543D2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519FC05D-86D7-F499-84AC-DD514FBA73D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3493453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B3C7C3E-4743-B8B4-3524-001DA4EC3869}"/>
              </a:ext>
            </a:extLst>
          </p:cNvPr>
          <p:cNvSpPr/>
          <p:nvPr/>
        </p:nvSpPr>
        <p:spPr>
          <a:xfrm>
            <a:off x="3149732" y="6100674"/>
            <a:ext cx="914282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n: Kaempferol docked human IL-6R (1n26)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8247918-AF3E-CD72-4C70-552703677FD0}"/>
              </a:ext>
            </a:extLst>
          </p:cNvPr>
          <p:cNvGrpSpPr/>
          <p:nvPr/>
        </p:nvGrpSpPr>
        <p:grpSpPr>
          <a:xfrm>
            <a:off x="3668671" y="259310"/>
            <a:ext cx="8241621" cy="5515405"/>
            <a:chOff x="756492" y="498510"/>
            <a:chExt cx="10679015" cy="5515405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48CBA74D-4D3A-A52E-4ED2-FACC84EB3BD5}"/>
                </a:ext>
              </a:extLst>
            </p:cNvPr>
            <p:cNvGrpSpPr/>
            <p:nvPr/>
          </p:nvGrpSpPr>
          <p:grpSpPr>
            <a:xfrm>
              <a:off x="756492" y="498510"/>
              <a:ext cx="10679015" cy="5515405"/>
              <a:chOff x="756492" y="571441"/>
              <a:chExt cx="10679015" cy="5515405"/>
            </a:xfrm>
          </p:grpSpPr>
          <p:pic>
            <p:nvPicPr>
              <p:cNvPr id="4" name="Picture 3" descr="A diagram of a molecule&#10;&#10;Description automatically generated">
                <a:extLst>
                  <a:ext uri="{FF2B5EF4-FFF2-40B4-BE49-F238E27FC236}">
                    <a16:creationId xmlns:a16="http://schemas.microsoft.com/office/drawing/2014/main" id="{8DFDB5A7-0717-A825-4092-076E3374D1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6492" y="771154"/>
                <a:ext cx="10679015" cy="5315692"/>
              </a:xfrm>
              <a:prstGeom prst="rect">
                <a:avLst/>
              </a:prstGeom>
            </p:spPr>
          </p:pic>
          <p:sp>
            <p:nvSpPr>
              <p:cNvPr id="3" name="Arrow: Right 2">
                <a:extLst>
                  <a:ext uri="{FF2B5EF4-FFF2-40B4-BE49-F238E27FC236}">
                    <a16:creationId xmlns:a16="http://schemas.microsoft.com/office/drawing/2014/main" id="{491E6923-2148-F11F-0EE2-1C2DE1C9903B}"/>
                  </a:ext>
                </a:extLst>
              </p:cNvPr>
              <p:cNvSpPr/>
              <p:nvPr/>
            </p:nvSpPr>
            <p:spPr>
              <a:xfrm rot="11401232">
                <a:off x="11010436" y="1321762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Arrow: Right 4">
                <a:extLst>
                  <a:ext uri="{FF2B5EF4-FFF2-40B4-BE49-F238E27FC236}">
                    <a16:creationId xmlns:a16="http://schemas.microsoft.com/office/drawing/2014/main" id="{C95EBF4A-7FCF-708A-4FFF-4ADE753D3105}"/>
                  </a:ext>
                </a:extLst>
              </p:cNvPr>
              <p:cNvSpPr/>
              <p:nvPr/>
            </p:nvSpPr>
            <p:spPr>
              <a:xfrm rot="16200000">
                <a:off x="9684319" y="4215791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Arrow: Right 8">
                <a:extLst>
                  <a:ext uri="{FF2B5EF4-FFF2-40B4-BE49-F238E27FC236}">
                    <a16:creationId xmlns:a16="http://schemas.microsoft.com/office/drawing/2014/main" id="{28E8D450-1095-7855-1164-0CCBE397E471}"/>
                  </a:ext>
                </a:extLst>
              </p:cNvPr>
              <p:cNvSpPr/>
              <p:nvPr/>
            </p:nvSpPr>
            <p:spPr>
              <a:xfrm rot="16200000">
                <a:off x="9042583" y="4415504"/>
                <a:ext cx="399426" cy="329784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Arrow: Right 9">
                <a:extLst>
                  <a:ext uri="{FF2B5EF4-FFF2-40B4-BE49-F238E27FC236}">
                    <a16:creationId xmlns:a16="http://schemas.microsoft.com/office/drawing/2014/main" id="{30AB88F7-2103-CE6B-9255-1ECC563ED219}"/>
                  </a:ext>
                </a:extLst>
              </p:cNvPr>
              <p:cNvSpPr/>
              <p:nvPr/>
            </p:nvSpPr>
            <p:spPr>
              <a:xfrm rot="5400000">
                <a:off x="9189948" y="606262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Arrow: Right 10">
                <a:extLst>
                  <a:ext uri="{FF2B5EF4-FFF2-40B4-BE49-F238E27FC236}">
                    <a16:creationId xmlns:a16="http://schemas.microsoft.com/office/drawing/2014/main" id="{A9CCF722-300A-5E81-2109-98327A0EA37B}"/>
                  </a:ext>
                </a:extLst>
              </p:cNvPr>
              <p:cNvSpPr/>
              <p:nvPr/>
            </p:nvSpPr>
            <p:spPr>
              <a:xfrm rot="5400000">
                <a:off x="7039415" y="1611809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Arrow: Right 5">
                <a:extLst>
                  <a:ext uri="{FF2B5EF4-FFF2-40B4-BE49-F238E27FC236}">
                    <a16:creationId xmlns:a16="http://schemas.microsoft.com/office/drawing/2014/main" id="{317409DC-0402-A45A-5033-CDA359CDA824}"/>
                  </a:ext>
                </a:extLst>
              </p:cNvPr>
              <p:cNvSpPr/>
              <p:nvPr/>
            </p:nvSpPr>
            <p:spPr>
              <a:xfrm rot="16200000">
                <a:off x="10768103" y="4247168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Star: 5 Points 14">
                <a:extLst>
                  <a:ext uri="{FF2B5EF4-FFF2-40B4-BE49-F238E27FC236}">
                    <a16:creationId xmlns:a16="http://schemas.microsoft.com/office/drawing/2014/main" id="{F8B54C30-E133-ACFA-83EE-E1EF616019CF}"/>
                  </a:ext>
                </a:extLst>
              </p:cNvPr>
              <p:cNvSpPr/>
              <p:nvPr/>
            </p:nvSpPr>
            <p:spPr>
              <a:xfrm>
                <a:off x="10025756" y="4096564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Star: 5 Points 15">
                <a:extLst>
                  <a:ext uri="{FF2B5EF4-FFF2-40B4-BE49-F238E27FC236}">
                    <a16:creationId xmlns:a16="http://schemas.microsoft.com/office/drawing/2014/main" id="{AEE4705B-5211-EF0A-E36C-32E26F09276F}"/>
                  </a:ext>
                </a:extLst>
              </p:cNvPr>
              <p:cNvSpPr/>
              <p:nvPr/>
            </p:nvSpPr>
            <p:spPr>
              <a:xfrm>
                <a:off x="9554553" y="899930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Star: 5 Points 16">
                <a:extLst>
                  <a:ext uri="{FF2B5EF4-FFF2-40B4-BE49-F238E27FC236}">
                    <a16:creationId xmlns:a16="http://schemas.microsoft.com/office/drawing/2014/main" id="{7C59E559-C3AD-0413-B8ED-1F17231D487E}"/>
                  </a:ext>
                </a:extLst>
              </p:cNvPr>
              <p:cNvSpPr/>
              <p:nvPr/>
            </p:nvSpPr>
            <p:spPr>
              <a:xfrm>
                <a:off x="10888516" y="1205121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Star: 5 Points 17">
                <a:extLst>
                  <a:ext uri="{FF2B5EF4-FFF2-40B4-BE49-F238E27FC236}">
                    <a16:creationId xmlns:a16="http://schemas.microsoft.com/office/drawing/2014/main" id="{C5FC58D9-A73E-6FEF-80EE-99C651C156B6}"/>
                  </a:ext>
                </a:extLst>
              </p:cNvPr>
              <p:cNvSpPr/>
              <p:nvPr/>
            </p:nvSpPr>
            <p:spPr>
              <a:xfrm>
                <a:off x="11184139" y="4127941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D10342D1-5A61-E2FD-32B8-6E5CD817F069}"/>
                </a:ext>
              </a:extLst>
            </p:cNvPr>
            <p:cNvSpPr/>
            <p:nvPr/>
          </p:nvSpPr>
          <p:spPr>
            <a:xfrm>
              <a:off x="6994936" y="1892008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56B43B3-C6CC-5A8F-BE97-BACA6BFCDF39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23" name="Picture 22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1D796168-C6D2-8678-FBE2-1FEBC8A46B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DD69B665-99BE-7A8D-C0DB-DF083DF1A266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59968464-13EE-2A2B-F12A-1D15810B45FA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FE9436FF-720A-3FEB-541E-5E3BD2FE3893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07652D5D-52F5-2F0C-6038-B31FAB27E8E8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tar: 5 Points 27">
              <a:extLst>
                <a:ext uri="{FF2B5EF4-FFF2-40B4-BE49-F238E27FC236}">
                  <a16:creationId xmlns:a16="http://schemas.microsoft.com/office/drawing/2014/main" id="{6A2126E8-2293-3F5A-FA1C-C02CD2687913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tar: 5 Points 28">
              <a:extLst>
                <a:ext uri="{FF2B5EF4-FFF2-40B4-BE49-F238E27FC236}">
                  <a16:creationId xmlns:a16="http://schemas.microsoft.com/office/drawing/2014/main" id="{1EFBBEAB-3291-6F87-75BB-81FBF100152B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Star: 5 Points 29">
              <a:extLst>
                <a:ext uri="{FF2B5EF4-FFF2-40B4-BE49-F238E27FC236}">
                  <a16:creationId xmlns:a16="http://schemas.microsoft.com/office/drawing/2014/main" id="{E9AD1133-9F75-5FCF-4192-0D435D643FCE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1319025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91FBF96-740A-67C7-3265-E05D9A7D1751}"/>
              </a:ext>
            </a:extLst>
          </p:cNvPr>
          <p:cNvSpPr/>
          <p:nvPr/>
        </p:nvSpPr>
        <p:spPr>
          <a:xfrm>
            <a:off x="2871820" y="6156897"/>
            <a:ext cx="932018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o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6R (1n26)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52B0BB0-12E2-80EA-135B-C9C006AC9CC7}"/>
              </a:ext>
            </a:extLst>
          </p:cNvPr>
          <p:cNvGrpSpPr/>
          <p:nvPr/>
        </p:nvGrpSpPr>
        <p:grpSpPr>
          <a:xfrm>
            <a:off x="3909039" y="116328"/>
            <a:ext cx="7992086" cy="5563503"/>
            <a:chOff x="818413" y="780680"/>
            <a:chExt cx="10555173" cy="5296639"/>
          </a:xfrm>
        </p:grpSpPr>
        <p:pic>
          <p:nvPicPr>
            <p:cNvPr id="3" name="Picture 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D1066067-616B-9F4A-3955-643E7A36C2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8413" y="780680"/>
              <a:ext cx="10555173" cy="5296639"/>
            </a:xfrm>
            <a:prstGeom prst="rect">
              <a:avLst/>
            </a:prstGeom>
          </p:spPr>
        </p:pic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C222251E-093D-98EA-FAD6-ADE3C52C4ADF}"/>
                </a:ext>
              </a:extLst>
            </p:cNvPr>
            <p:cNvSpPr/>
            <p:nvPr/>
          </p:nvSpPr>
          <p:spPr>
            <a:xfrm>
              <a:off x="9162651" y="4448566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7E9E312E-61DC-9B76-C17A-E2D3557B1DD7}"/>
                </a:ext>
              </a:extLst>
            </p:cNvPr>
            <p:cNvSpPr/>
            <p:nvPr/>
          </p:nvSpPr>
          <p:spPr>
            <a:xfrm>
              <a:off x="8227256" y="1714500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C480A32B-EBA9-0DD8-9A2A-FA4D813FA535}"/>
                </a:ext>
              </a:extLst>
            </p:cNvPr>
            <p:cNvSpPr/>
            <p:nvPr/>
          </p:nvSpPr>
          <p:spPr>
            <a:xfrm>
              <a:off x="8153347" y="4094889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286710C9-01E8-8231-0BD4-97E14681A799}"/>
                </a:ext>
              </a:extLst>
            </p:cNvPr>
            <p:cNvSpPr/>
            <p:nvPr/>
          </p:nvSpPr>
          <p:spPr>
            <a:xfrm>
              <a:off x="9322244" y="3340363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EA75E72D-586C-A4B2-3BC0-BEC00D1DD115}"/>
                </a:ext>
              </a:extLst>
            </p:cNvPr>
            <p:cNvSpPr/>
            <p:nvPr/>
          </p:nvSpPr>
          <p:spPr>
            <a:xfrm>
              <a:off x="9596092" y="3963745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03F613DB-9056-58A1-6902-FBCAC5603041}"/>
                </a:ext>
              </a:extLst>
            </p:cNvPr>
            <p:cNvSpPr/>
            <p:nvPr/>
          </p:nvSpPr>
          <p:spPr>
            <a:xfrm>
              <a:off x="7412568" y="3615448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331B8A23-7ADF-02E1-29EB-3375A6E0B7ED}"/>
                </a:ext>
              </a:extLst>
            </p:cNvPr>
            <p:cNvSpPr/>
            <p:nvPr/>
          </p:nvSpPr>
          <p:spPr>
            <a:xfrm>
              <a:off x="10519650" y="3084354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35780556-96DC-EC75-4A77-BB6D88BA854C}"/>
                </a:ext>
              </a:extLst>
            </p:cNvPr>
            <p:cNvSpPr/>
            <p:nvPr/>
          </p:nvSpPr>
          <p:spPr>
            <a:xfrm>
              <a:off x="10756092" y="2293798"/>
              <a:ext cx="147817" cy="128368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CE73163-3954-D321-6C1A-DB0F132B8CFB}"/>
              </a:ext>
            </a:extLst>
          </p:cNvPr>
          <p:cNvGrpSpPr/>
          <p:nvPr/>
        </p:nvGrpSpPr>
        <p:grpSpPr>
          <a:xfrm>
            <a:off x="0" y="51767"/>
            <a:ext cx="4149969" cy="2568607"/>
            <a:chOff x="990600" y="281586"/>
            <a:chExt cx="9215948" cy="5551196"/>
          </a:xfrm>
        </p:grpSpPr>
        <p:pic>
          <p:nvPicPr>
            <p:cNvPr id="15" name="Picture 14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FD751F65-90C2-1092-74F9-099708932B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3DD57F7D-5513-C503-29EE-920079C5BAB4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09762CE1-205B-347B-BF5C-761CAAD598B5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17A60228-6CDC-A3C6-DD13-3C2FCB6FCBF9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941666C3-3EE1-5F4A-2976-F86CF75FCC35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412329D0-4A84-764F-59DA-4F9CE3A02C4C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8D92D609-30A5-DE0D-D8DF-C5514C615466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3B4765FE-B92E-17ED-48FE-B1DDCC2EA795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7859462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del&#10;&#10;AI-generated content may be incorrect.">
            <a:extLst>
              <a:ext uri="{FF2B5EF4-FFF2-40B4-BE49-F238E27FC236}">
                <a16:creationId xmlns:a16="http://schemas.microsoft.com/office/drawing/2014/main" id="{B4478E8C-6664-AB33-D687-9676795840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485" y="1151611"/>
            <a:ext cx="8967000" cy="421486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2836215-3AB6-A443-A48F-BB28FAD8269A}"/>
              </a:ext>
            </a:extLst>
          </p:cNvPr>
          <p:cNvSpPr/>
          <p:nvPr/>
        </p:nvSpPr>
        <p:spPr>
          <a:xfrm>
            <a:off x="1678132" y="5812123"/>
            <a:ext cx="921919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p: Nitazoxanide docked human IL-6R (1n26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011BD8E-39BB-1B38-2D6C-ABA4D3E6BDF2}"/>
              </a:ext>
            </a:extLst>
          </p:cNvPr>
          <p:cNvGrpSpPr/>
          <p:nvPr/>
        </p:nvGrpSpPr>
        <p:grpSpPr>
          <a:xfrm>
            <a:off x="0" y="146465"/>
            <a:ext cx="4781862" cy="2641705"/>
            <a:chOff x="990600" y="281586"/>
            <a:chExt cx="9215948" cy="5551196"/>
          </a:xfrm>
        </p:grpSpPr>
        <p:pic>
          <p:nvPicPr>
            <p:cNvPr id="6" name="Picture 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7043BE4F-DA21-90BB-EF9F-3694C2A685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1ED564E3-2A8B-9FDA-40D2-B73976898375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10F7F9E1-7059-BCC0-B5D1-5F85C24D50B9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174A07E2-E3C9-9F60-A84C-124950D4FB39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12926299-DF14-C12C-B4A2-D65199E5A0B9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43B1F914-66F9-FFB9-BFBF-6C8F3A0E5F84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A7798556-50A8-5819-A34F-A9AFB3DD8F64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7F35B115-88F2-0E80-ECFE-5BA5BE98FE9D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F87222CF-3E1F-60C5-087D-4631D8170556}"/>
              </a:ext>
            </a:extLst>
          </p:cNvPr>
          <p:cNvSpPr/>
          <p:nvPr/>
        </p:nvSpPr>
        <p:spPr>
          <a:xfrm>
            <a:off x="11123398" y="2034933"/>
            <a:ext cx="131013" cy="97742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EE7D5B2C-CD7E-50C1-BEE2-8462A0049F2D}"/>
              </a:ext>
            </a:extLst>
          </p:cNvPr>
          <p:cNvSpPr/>
          <p:nvPr/>
        </p:nvSpPr>
        <p:spPr>
          <a:xfrm>
            <a:off x="10616231" y="1787733"/>
            <a:ext cx="131013" cy="97742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86F63EC3-6537-DA8E-4FDA-9A9A91A8708A}"/>
              </a:ext>
            </a:extLst>
          </p:cNvPr>
          <p:cNvSpPr/>
          <p:nvPr/>
        </p:nvSpPr>
        <p:spPr>
          <a:xfrm>
            <a:off x="9399405" y="3689081"/>
            <a:ext cx="82845" cy="6073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C5E0714A-0EDB-6767-67E9-BC5B7A2B7731}"/>
              </a:ext>
            </a:extLst>
          </p:cNvPr>
          <p:cNvSpPr/>
          <p:nvPr/>
        </p:nvSpPr>
        <p:spPr>
          <a:xfrm>
            <a:off x="8841871" y="3796504"/>
            <a:ext cx="82845" cy="6073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70CE23AF-56E0-A0B3-B510-F6AE48CF4AF6}"/>
              </a:ext>
            </a:extLst>
          </p:cNvPr>
          <p:cNvSpPr/>
          <p:nvPr/>
        </p:nvSpPr>
        <p:spPr>
          <a:xfrm>
            <a:off x="8924716" y="3198312"/>
            <a:ext cx="82845" cy="6073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EB5294B4-6657-44DF-8423-6364514A969C}"/>
              </a:ext>
            </a:extLst>
          </p:cNvPr>
          <p:cNvSpPr/>
          <p:nvPr/>
        </p:nvSpPr>
        <p:spPr>
          <a:xfrm>
            <a:off x="11494510" y="3429000"/>
            <a:ext cx="131013" cy="97742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2D711ACF-B43C-F8BE-B5F9-36007769D26E}"/>
              </a:ext>
            </a:extLst>
          </p:cNvPr>
          <p:cNvSpPr/>
          <p:nvPr/>
        </p:nvSpPr>
        <p:spPr>
          <a:xfrm>
            <a:off x="9911005" y="3727588"/>
            <a:ext cx="84462" cy="99282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19D9BA8E-E704-B216-6250-D859E2D600EC}"/>
              </a:ext>
            </a:extLst>
          </p:cNvPr>
          <p:cNvSpPr/>
          <p:nvPr/>
        </p:nvSpPr>
        <p:spPr>
          <a:xfrm>
            <a:off x="10185695" y="3905974"/>
            <a:ext cx="84462" cy="99282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ACA56624-C6D9-F8C2-5795-6611D08B360F}"/>
              </a:ext>
            </a:extLst>
          </p:cNvPr>
          <p:cNvSpPr/>
          <p:nvPr/>
        </p:nvSpPr>
        <p:spPr>
          <a:xfrm>
            <a:off x="10779456" y="4113298"/>
            <a:ext cx="84462" cy="99282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93978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DE010802-9697-66EC-5693-447CC3EDD0E0}"/>
              </a:ext>
            </a:extLst>
          </p:cNvPr>
          <p:cNvGrpSpPr/>
          <p:nvPr/>
        </p:nvGrpSpPr>
        <p:grpSpPr>
          <a:xfrm>
            <a:off x="3976165" y="463703"/>
            <a:ext cx="8114722" cy="5827536"/>
            <a:chOff x="689808" y="607521"/>
            <a:chExt cx="10812384" cy="5479325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5321122-CC62-BCE0-52B4-C1A4E5A1C0DB}"/>
                </a:ext>
              </a:extLst>
            </p:cNvPr>
            <p:cNvGrpSpPr/>
            <p:nvPr/>
          </p:nvGrpSpPr>
          <p:grpSpPr>
            <a:xfrm>
              <a:off x="689808" y="607521"/>
              <a:ext cx="10812384" cy="5479325"/>
              <a:chOff x="689808" y="607521"/>
              <a:chExt cx="10812384" cy="547932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D93616CF-203B-F4B0-28CC-3667CE7A9C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89808" y="771154"/>
                <a:ext cx="10812384" cy="5315692"/>
              </a:xfrm>
              <a:prstGeom prst="rect">
                <a:avLst/>
              </a:prstGeom>
            </p:spPr>
          </p:pic>
          <p:sp>
            <p:nvSpPr>
              <p:cNvPr id="5" name="Arrow: Right 4">
                <a:extLst>
                  <a:ext uri="{FF2B5EF4-FFF2-40B4-BE49-F238E27FC236}">
                    <a16:creationId xmlns:a16="http://schemas.microsoft.com/office/drawing/2014/main" id="{B813D59A-1B38-9BE9-4698-0EDD4375763E}"/>
                  </a:ext>
                </a:extLst>
              </p:cNvPr>
              <p:cNvSpPr/>
              <p:nvPr/>
            </p:nvSpPr>
            <p:spPr>
              <a:xfrm rot="5400000">
                <a:off x="9434293" y="642342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Arrow: Right 5">
                <a:extLst>
                  <a:ext uri="{FF2B5EF4-FFF2-40B4-BE49-F238E27FC236}">
                    <a16:creationId xmlns:a16="http://schemas.microsoft.com/office/drawing/2014/main" id="{ACABB736-E6A0-E076-994F-36B321D9D95F}"/>
                  </a:ext>
                </a:extLst>
              </p:cNvPr>
              <p:cNvSpPr/>
              <p:nvPr/>
            </p:nvSpPr>
            <p:spPr>
              <a:xfrm rot="16733020">
                <a:off x="8341680" y="5066120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Arrow: Right 6">
                <a:extLst>
                  <a:ext uri="{FF2B5EF4-FFF2-40B4-BE49-F238E27FC236}">
                    <a16:creationId xmlns:a16="http://schemas.microsoft.com/office/drawing/2014/main" id="{105387B8-1B21-7A44-79C8-487B182EB219}"/>
                  </a:ext>
                </a:extLst>
              </p:cNvPr>
              <p:cNvSpPr/>
              <p:nvPr/>
            </p:nvSpPr>
            <p:spPr>
              <a:xfrm rot="5400000">
                <a:off x="6845581" y="2963833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Arrow: Right 7">
                <a:extLst>
                  <a:ext uri="{FF2B5EF4-FFF2-40B4-BE49-F238E27FC236}">
                    <a16:creationId xmlns:a16="http://schemas.microsoft.com/office/drawing/2014/main" id="{7207F5B2-4531-9D8B-6A02-31BA0FB9A849}"/>
                  </a:ext>
                </a:extLst>
              </p:cNvPr>
              <p:cNvSpPr/>
              <p:nvPr/>
            </p:nvSpPr>
            <p:spPr>
              <a:xfrm rot="5400000">
                <a:off x="7566107" y="909550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Star: 5 Points 10">
                <a:extLst>
                  <a:ext uri="{FF2B5EF4-FFF2-40B4-BE49-F238E27FC236}">
                    <a16:creationId xmlns:a16="http://schemas.microsoft.com/office/drawing/2014/main" id="{41DD53C5-32FB-2C80-1F73-062B8757EE7D}"/>
                  </a:ext>
                </a:extLst>
              </p:cNvPr>
              <p:cNvSpPr/>
              <p:nvPr/>
            </p:nvSpPr>
            <p:spPr>
              <a:xfrm>
                <a:off x="7521628" y="1268976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C7AADCC9-253D-E3DA-864D-9EE298977287}"/>
                </a:ext>
              </a:extLst>
            </p:cNvPr>
            <p:cNvSpPr/>
            <p:nvPr/>
          </p:nvSpPr>
          <p:spPr>
            <a:xfrm>
              <a:off x="6801102" y="3244032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7B088484-8DCA-7320-FA20-D57A6073C332}"/>
              </a:ext>
            </a:extLst>
          </p:cNvPr>
          <p:cNvSpPr/>
          <p:nvPr/>
        </p:nvSpPr>
        <p:spPr>
          <a:xfrm>
            <a:off x="3976166" y="6213760"/>
            <a:ext cx="811472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q: Phytic docked human IL-6R (1n26)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E152E3A-7425-3EE2-AE66-99BA0F0A312B}"/>
              </a:ext>
            </a:extLst>
          </p:cNvPr>
          <p:cNvGrpSpPr/>
          <p:nvPr/>
        </p:nvGrpSpPr>
        <p:grpSpPr>
          <a:xfrm>
            <a:off x="0" y="51767"/>
            <a:ext cx="4171616" cy="2568341"/>
            <a:chOff x="990600" y="281586"/>
            <a:chExt cx="9215948" cy="5551196"/>
          </a:xfrm>
        </p:grpSpPr>
        <p:pic>
          <p:nvPicPr>
            <p:cNvPr id="12" name="Picture 11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10D90DDC-5DD4-717E-F464-0C2691EB6ED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DB555653-15C0-9D13-0B1A-A2E613EBBB68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925D94B4-28CA-17E2-CAB1-0E8B23C5CD6B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654F8EEA-0F13-269E-980B-BC2A1CC2D0B7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59640269-D2E5-8705-8FD6-AF8337EF7E24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FBADD129-9D4F-D000-2F7E-0FC3D3C58F51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A2B79B4E-C66B-CAD7-71DE-94E37B1C8879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1BFA1936-B03E-025A-968A-6B43264D322E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204127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E134C323-A998-D3A9-C449-B40E343688C9}"/>
              </a:ext>
            </a:extLst>
          </p:cNvPr>
          <p:cNvGrpSpPr/>
          <p:nvPr/>
        </p:nvGrpSpPr>
        <p:grpSpPr>
          <a:xfrm>
            <a:off x="990600" y="281586"/>
            <a:ext cx="9215948" cy="5551196"/>
            <a:chOff x="990600" y="281586"/>
            <a:chExt cx="9215948" cy="5551196"/>
          </a:xfrm>
        </p:grpSpPr>
        <p:pic>
          <p:nvPicPr>
            <p:cNvPr id="3" name="Picture 2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78C55CE-7383-2079-94CE-63250F220D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8069842D-4EEE-8C99-49C2-E0687985119D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C50972B5-473C-FCED-F8FA-46C6A8158763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6FC46149-1F09-5D7C-6C37-661F74115363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CA71DC3F-CA69-1F10-E260-4FFAD75EBF57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DBDA3E3D-6FA4-E20D-BAA1-D7980DEAB5FF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25CF4685-F0CC-A26C-1F0B-3998F7C4D988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745EB0D0-1B51-9504-1980-DCFC6EC42761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81033278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9234F11-0422-4E6B-8DDB-1AE3344DF233}"/>
              </a:ext>
            </a:extLst>
          </p:cNvPr>
          <p:cNvSpPr/>
          <p:nvPr/>
        </p:nvSpPr>
        <p:spPr>
          <a:xfrm>
            <a:off x="3404851" y="6253493"/>
            <a:ext cx="878714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r: Quercetin docked human IL-6R (1n26)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BB2DFF7-99A2-7C87-CA21-EB4D039868D8}"/>
              </a:ext>
            </a:extLst>
          </p:cNvPr>
          <p:cNvGrpSpPr/>
          <p:nvPr/>
        </p:nvGrpSpPr>
        <p:grpSpPr>
          <a:xfrm>
            <a:off x="3552091" y="1160584"/>
            <a:ext cx="8481647" cy="5145717"/>
            <a:chOff x="779798" y="1369149"/>
            <a:chExt cx="11412202" cy="5488851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FBED198B-05F8-A17C-20AC-8027C191BBFA}"/>
                </a:ext>
              </a:extLst>
            </p:cNvPr>
            <p:cNvGrpSpPr/>
            <p:nvPr/>
          </p:nvGrpSpPr>
          <p:grpSpPr>
            <a:xfrm>
              <a:off x="779798" y="1369149"/>
              <a:ext cx="11412202" cy="5488851"/>
              <a:chOff x="489755" y="607521"/>
              <a:chExt cx="11412202" cy="5488851"/>
            </a:xfrm>
          </p:grpSpPr>
          <p:pic>
            <p:nvPicPr>
              <p:cNvPr id="6" name="Picture 5" descr="A close-up of a computer screen&#10;&#10;Description automatically generated">
                <a:extLst>
                  <a:ext uri="{FF2B5EF4-FFF2-40B4-BE49-F238E27FC236}">
                    <a16:creationId xmlns:a16="http://schemas.microsoft.com/office/drawing/2014/main" id="{DA55956D-38B2-B793-09CB-F680399A22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9755" y="761628"/>
                <a:ext cx="11212490" cy="5334744"/>
              </a:xfrm>
              <a:prstGeom prst="rect">
                <a:avLst/>
              </a:prstGeom>
            </p:spPr>
          </p:pic>
          <p:sp>
            <p:nvSpPr>
              <p:cNvPr id="3" name="Arrow: Right 2">
                <a:extLst>
                  <a:ext uri="{FF2B5EF4-FFF2-40B4-BE49-F238E27FC236}">
                    <a16:creationId xmlns:a16="http://schemas.microsoft.com/office/drawing/2014/main" id="{0DC5F109-E6AC-2D85-DC3B-CA7A19B1FDFF}"/>
                  </a:ext>
                </a:extLst>
              </p:cNvPr>
              <p:cNvSpPr/>
              <p:nvPr/>
            </p:nvSpPr>
            <p:spPr>
              <a:xfrm rot="16200000">
                <a:off x="8659767" y="4543662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Arrow: Right 6">
                <a:extLst>
                  <a:ext uri="{FF2B5EF4-FFF2-40B4-BE49-F238E27FC236}">
                    <a16:creationId xmlns:a16="http://schemas.microsoft.com/office/drawing/2014/main" id="{C6832ACB-7094-6E25-8D91-06DDF85839DD}"/>
                  </a:ext>
                </a:extLst>
              </p:cNvPr>
              <p:cNvSpPr/>
              <p:nvPr/>
            </p:nvSpPr>
            <p:spPr>
              <a:xfrm rot="5581580">
                <a:off x="6707793" y="714631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Arrow: Right 7">
                <a:extLst>
                  <a:ext uri="{FF2B5EF4-FFF2-40B4-BE49-F238E27FC236}">
                    <a16:creationId xmlns:a16="http://schemas.microsoft.com/office/drawing/2014/main" id="{D58A1AC8-5837-A59C-E6BD-08C2E9AEEFF1}"/>
                  </a:ext>
                </a:extLst>
              </p:cNvPr>
              <p:cNvSpPr/>
              <p:nvPr/>
            </p:nvSpPr>
            <p:spPr>
              <a:xfrm rot="5400000">
                <a:off x="10594442" y="921861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Arrow: Right 8">
                <a:extLst>
                  <a:ext uri="{FF2B5EF4-FFF2-40B4-BE49-F238E27FC236}">
                    <a16:creationId xmlns:a16="http://schemas.microsoft.com/office/drawing/2014/main" id="{B5A9D28E-3C9B-8598-8A53-E27668324ACE}"/>
                  </a:ext>
                </a:extLst>
              </p:cNvPr>
              <p:cNvSpPr/>
              <p:nvPr/>
            </p:nvSpPr>
            <p:spPr>
              <a:xfrm rot="18505319">
                <a:off x="7358210" y="4458843"/>
                <a:ext cx="399426" cy="329784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Arrow: Right 9">
                <a:extLst>
                  <a:ext uri="{FF2B5EF4-FFF2-40B4-BE49-F238E27FC236}">
                    <a16:creationId xmlns:a16="http://schemas.microsoft.com/office/drawing/2014/main" id="{6517A73E-C894-E517-3FBD-DCEA670C7E00}"/>
                  </a:ext>
                </a:extLst>
              </p:cNvPr>
              <p:cNvSpPr/>
              <p:nvPr/>
            </p:nvSpPr>
            <p:spPr>
              <a:xfrm rot="5400000">
                <a:off x="9434293" y="642342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Star: 5 Points 13">
                <a:extLst>
                  <a:ext uri="{FF2B5EF4-FFF2-40B4-BE49-F238E27FC236}">
                    <a16:creationId xmlns:a16="http://schemas.microsoft.com/office/drawing/2014/main" id="{49DD26F8-2F81-E328-1117-CED5D349B153}"/>
                  </a:ext>
                </a:extLst>
              </p:cNvPr>
              <p:cNvSpPr/>
              <p:nvPr/>
            </p:nvSpPr>
            <p:spPr>
              <a:xfrm>
                <a:off x="8499280" y="4508841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Star: 5 Points 15">
                <a:extLst>
                  <a:ext uri="{FF2B5EF4-FFF2-40B4-BE49-F238E27FC236}">
                    <a16:creationId xmlns:a16="http://schemas.microsoft.com/office/drawing/2014/main" id="{18535703-31C9-B4BC-F8DC-54B2323DA9C9}"/>
                  </a:ext>
                </a:extLst>
              </p:cNvPr>
              <p:cNvSpPr/>
              <p:nvPr/>
            </p:nvSpPr>
            <p:spPr>
              <a:xfrm>
                <a:off x="9324582" y="874729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Star: 5 Points 17">
                <a:extLst>
                  <a:ext uri="{FF2B5EF4-FFF2-40B4-BE49-F238E27FC236}">
                    <a16:creationId xmlns:a16="http://schemas.microsoft.com/office/drawing/2014/main" id="{7DB785A2-0831-1033-13EE-FF953E09BB96}"/>
                  </a:ext>
                </a:extLst>
              </p:cNvPr>
              <p:cNvSpPr/>
              <p:nvPr/>
            </p:nvSpPr>
            <p:spPr>
              <a:xfrm>
                <a:off x="6573700" y="887040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Arrow: Right 4">
                <a:extLst>
                  <a:ext uri="{FF2B5EF4-FFF2-40B4-BE49-F238E27FC236}">
                    <a16:creationId xmlns:a16="http://schemas.microsoft.com/office/drawing/2014/main" id="{642169DE-7475-6012-1AE8-2AC60F686CCC}"/>
                  </a:ext>
                </a:extLst>
              </p:cNvPr>
              <p:cNvSpPr/>
              <p:nvPr/>
            </p:nvSpPr>
            <p:spPr>
              <a:xfrm rot="8413212">
                <a:off x="11502531" y="2055987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6451F3BE-5031-D74A-0537-EBEF466A438C}"/>
                </a:ext>
              </a:extLst>
            </p:cNvPr>
            <p:cNvSpPr/>
            <p:nvPr/>
          </p:nvSpPr>
          <p:spPr>
            <a:xfrm>
              <a:off x="10813406" y="1904224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65C4261F-9805-67F6-32C9-BA32521559FA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26" name="Picture 2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0420F9E2-BFE3-AFA1-1A98-F7D421A783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24499425-73C3-73F8-3D3B-2592C75A99EF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tar: 5 Points 27">
              <a:extLst>
                <a:ext uri="{FF2B5EF4-FFF2-40B4-BE49-F238E27FC236}">
                  <a16:creationId xmlns:a16="http://schemas.microsoft.com/office/drawing/2014/main" id="{55D91D23-E890-5CB7-6B5C-829A8BB0F37A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tar: 5 Points 28">
              <a:extLst>
                <a:ext uri="{FF2B5EF4-FFF2-40B4-BE49-F238E27FC236}">
                  <a16:creationId xmlns:a16="http://schemas.microsoft.com/office/drawing/2014/main" id="{032FC6A0-9E57-A79F-8FE6-9AF60379D148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Star: 5 Points 29">
              <a:extLst>
                <a:ext uri="{FF2B5EF4-FFF2-40B4-BE49-F238E27FC236}">
                  <a16:creationId xmlns:a16="http://schemas.microsoft.com/office/drawing/2014/main" id="{C92E0B28-DFDD-5BC8-BBC6-FC67CE90B421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Star: 5 Points 30">
              <a:extLst>
                <a:ext uri="{FF2B5EF4-FFF2-40B4-BE49-F238E27FC236}">
                  <a16:creationId xmlns:a16="http://schemas.microsoft.com/office/drawing/2014/main" id="{E76058D1-62B0-00C7-F0D3-A0B59E37807E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Star: 5 Points 31">
              <a:extLst>
                <a:ext uri="{FF2B5EF4-FFF2-40B4-BE49-F238E27FC236}">
                  <a16:creationId xmlns:a16="http://schemas.microsoft.com/office/drawing/2014/main" id="{B0BE1A36-F4DB-815C-BE21-FDB53BD02395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Star: 5 Points 32">
              <a:extLst>
                <a:ext uri="{FF2B5EF4-FFF2-40B4-BE49-F238E27FC236}">
                  <a16:creationId xmlns:a16="http://schemas.microsoft.com/office/drawing/2014/main" id="{C222A175-AE6B-1F2F-83AD-3C0E8BC2421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23435357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35C6D447-DDBD-2ED7-C2A6-B64854E06F9D}"/>
              </a:ext>
            </a:extLst>
          </p:cNvPr>
          <p:cNvSpPr/>
          <p:nvPr/>
        </p:nvSpPr>
        <p:spPr>
          <a:xfrm>
            <a:off x="3440886" y="6163400"/>
            <a:ext cx="875111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s: Quinapril docked human IL-6R (1n26)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6B8655B-2D0B-84BA-6472-171F21A79A3F}"/>
              </a:ext>
            </a:extLst>
          </p:cNvPr>
          <p:cNvGrpSpPr/>
          <p:nvPr/>
        </p:nvGrpSpPr>
        <p:grpSpPr>
          <a:xfrm>
            <a:off x="3604846" y="386861"/>
            <a:ext cx="8110187" cy="5644661"/>
            <a:chOff x="1022088" y="1282998"/>
            <a:chExt cx="10745700" cy="5315692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E68810C-494C-9C8C-3259-0861A51CAF26}"/>
                </a:ext>
              </a:extLst>
            </p:cNvPr>
            <p:cNvGrpSpPr/>
            <p:nvPr/>
          </p:nvGrpSpPr>
          <p:grpSpPr>
            <a:xfrm>
              <a:off x="1022088" y="1282998"/>
              <a:ext cx="10745700" cy="5315692"/>
              <a:chOff x="723150" y="771154"/>
              <a:chExt cx="10745700" cy="5315692"/>
            </a:xfrm>
          </p:grpSpPr>
          <p:pic>
            <p:nvPicPr>
              <p:cNvPr id="3" name="Picture 2" descr="A close-up of a model of a molecule&#10;&#10;Description automatically generated">
                <a:extLst>
                  <a:ext uri="{FF2B5EF4-FFF2-40B4-BE49-F238E27FC236}">
                    <a16:creationId xmlns:a16="http://schemas.microsoft.com/office/drawing/2014/main" id="{A3E5D1BC-84D3-A72B-CC7A-DE6A99D016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3150" y="771154"/>
                <a:ext cx="10745700" cy="5315692"/>
              </a:xfrm>
              <a:prstGeom prst="rect">
                <a:avLst/>
              </a:prstGeom>
            </p:spPr>
          </p:pic>
          <p:sp>
            <p:nvSpPr>
              <p:cNvPr id="2" name="Arrow: Right 1">
                <a:extLst>
                  <a:ext uri="{FF2B5EF4-FFF2-40B4-BE49-F238E27FC236}">
                    <a16:creationId xmlns:a16="http://schemas.microsoft.com/office/drawing/2014/main" id="{E65D0766-68CB-47D7-60A9-C2507F99805E}"/>
                  </a:ext>
                </a:extLst>
              </p:cNvPr>
              <p:cNvSpPr/>
              <p:nvPr/>
            </p:nvSpPr>
            <p:spPr>
              <a:xfrm rot="18505319">
                <a:off x="7032533" y="4671786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Arrow: Right 5">
                <a:extLst>
                  <a:ext uri="{FF2B5EF4-FFF2-40B4-BE49-F238E27FC236}">
                    <a16:creationId xmlns:a16="http://schemas.microsoft.com/office/drawing/2014/main" id="{FF4954DC-B44F-D55F-3623-1D2C4F670DD2}"/>
                  </a:ext>
                </a:extLst>
              </p:cNvPr>
              <p:cNvSpPr/>
              <p:nvPr/>
            </p:nvSpPr>
            <p:spPr>
              <a:xfrm rot="18505319">
                <a:off x="8770889" y="4199905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Arrow: Right 6">
                <a:extLst>
                  <a:ext uri="{FF2B5EF4-FFF2-40B4-BE49-F238E27FC236}">
                    <a16:creationId xmlns:a16="http://schemas.microsoft.com/office/drawing/2014/main" id="{2CA805BF-FDBE-6A24-CA5B-3E08E3737BBF}"/>
                  </a:ext>
                </a:extLst>
              </p:cNvPr>
              <p:cNvSpPr/>
              <p:nvPr/>
            </p:nvSpPr>
            <p:spPr>
              <a:xfrm rot="9701143">
                <a:off x="10013727" y="1792076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Star: 5 Points 8">
                <a:extLst>
                  <a:ext uri="{FF2B5EF4-FFF2-40B4-BE49-F238E27FC236}">
                    <a16:creationId xmlns:a16="http://schemas.microsoft.com/office/drawing/2014/main" id="{6DEC54FB-1BC2-4611-5DCD-C4EF42F91111}"/>
                  </a:ext>
                </a:extLst>
              </p:cNvPr>
              <p:cNvSpPr/>
              <p:nvPr/>
            </p:nvSpPr>
            <p:spPr>
              <a:xfrm>
                <a:off x="9972029" y="1653266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Star: 5 Points 9">
                <a:extLst>
                  <a:ext uri="{FF2B5EF4-FFF2-40B4-BE49-F238E27FC236}">
                    <a16:creationId xmlns:a16="http://schemas.microsoft.com/office/drawing/2014/main" id="{1F1603A1-6DA4-06FD-2ABD-83996DAD9DFB}"/>
                  </a:ext>
                </a:extLst>
              </p:cNvPr>
              <p:cNvSpPr/>
              <p:nvPr/>
            </p:nvSpPr>
            <p:spPr>
              <a:xfrm>
                <a:off x="7261682" y="1995701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Star: 5 Points 10">
                <a:extLst>
                  <a:ext uri="{FF2B5EF4-FFF2-40B4-BE49-F238E27FC236}">
                    <a16:creationId xmlns:a16="http://schemas.microsoft.com/office/drawing/2014/main" id="{DF22DB28-EED9-9341-B26F-56A5625604FD}"/>
                  </a:ext>
                </a:extLst>
              </p:cNvPr>
              <p:cNvSpPr/>
              <p:nvPr/>
            </p:nvSpPr>
            <p:spPr>
              <a:xfrm>
                <a:off x="8891691" y="4021452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Arrow: Right 12">
                <a:extLst>
                  <a:ext uri="{FF2B5EF4-FFF2-40B4-BE49-F238E27FC236}">
                    <a16:creationId xmlns:a16="http://schemas.microsoft.com/office/drawing/2014/main" id="{87C1274D-1504-053A-D715-BF6A39B0C7AE}"/>
                  </a:ext>
                </a:extLst>
              </p:cNvPr>
              <p:cNvSpPr/>
              <p:nvPr/>
            </p:nvSpPr>
            <p:spPr>
              <a:xfrm rot="16200000">
                <a:off x="10990278" y="4272578"/>
                <a:ext cx="399426" cy="329784"/>
              </a:xfrm>
              <a:prstGeom prst="rightArrow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Star: 5 Points 3">
                <a:extLst>
                  <a:ext uri="{FF2B5EF4-FFF2-40B4-BE49-F238E27FC236}">
                    <a16:creationId xmlns:a16="http://schemas.microsoft.com/office/drawing/2014/main" id="{6AEF59A4-37F8-4AF9-DDE4-43E0EF0CB7DC}"/>
                  </a:ext>
                </a:extLst>
              </p:cNvPr>
              <p:cNvSpPr/>
              <p:nvPr/>
            </p:nvSpPr>
            <p:spPr>
              <a:xfrm>
                <a:off x="11310250" y="4105858"/>
                <a:ext cx="158600" cy="168812"/>
              </a:xfrm>
              <a:prstGeom prst="star5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8DAA7FBD-45F1-083A-223F-6695A0EB5791}"/>
                </a:ext>
              </a:extLst>
            </p:cNvPr>
            <p:cNvSpPr/>
            <p:nvPr/>
          </p:nvSpPr>
          <p:spPr>
            <a:xfrm rot="18505319">
              <a:off x="7519505" y="2825756"/>
              <a:ext cx="399426" cy="329784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4DD59F8-3AC6-4AA3-0A3C-8BB0462A2722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9" name="Picture 18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9ADA0C0F-183E-423A-8718-F613E9A51E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60448389-92E8-D318-2FDA-274E17A467CB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7A934FBB-7CD8-EE58-8E74-25BFD2E3FC2C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1AE87FBE-11D7-A24C-37D2-F722929FFCDF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B3D29599-BBE5-6F3F-7442-D24505C15336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8411BF54-38B7-C127-75EC-F7F1DCA82C6F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0D003073-B8CE-413C-8CB9-7C561F33120A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4557FE28-887E-BB24-334D-4B8EF07382BA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4122405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5C1C5BC-5AF4-8AFF-61C5-6D8B2033A58A}"/>
              </a:ext>
            </a:extLst>
          </p:cNvPr>
          <p:cNvSpPr/>
          <p:nvPr/>
        </p:nvSpPr>
        <p:spPr>
          <a:xfrm>
            <a:off x="3266159" y="6099665"/>
            <a:ext cx="892584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t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6R (1n26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AA15BE3-8CF8-EBB1-4AFD-2C591391663F}"/>
              </a:ext>
            </a:extLst>
          </p:cNvPr>
          <p:cNvGrpSpPr/>
          <p:nvPr/>
        </p:nvGrpSpPr>
        <p:grpSpPr>
          <a:xfrm>
            <a:off x="4097215" y="668215"/>
            <a:ext cx="7754816" cy="5273190"/>
            <a:chOff x="832703" y="775917"/>
            <a:chExt cx="10526594" cy="5306165"/>
          </a:xfrm>
        </p:grpSpPr>
        <p:pic>
          <p:nvPicPr>
            <p:cNvPr id="3" name="Picture 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45164B39-EA68-57AB-4F31-85986CAF39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703" y="775917"/>
              <a:ext cx="10526594" cy="5306165"/>
            </a:xfrm>
            <a:prstGeom prst="rect">
              <a:avLst/>
            </a:prstGeom>
          </p:spPr>
        </p:pic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AA9CABE8-D051-70E1-EDA1-9CD4B62953BC}"/>
                </a:ext>
              </a:extLst>
            </p:cNvPr>
            <p:cNvSpPr/>
            <p:nvPr/>
          </p:nvSpPr>
          <p:spPr>
            <a:xfrm>
              <a:off x="7940208" y="3324684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98B352AD-D9C9-9E5C-A70D-E940B1F054A3}"/>
                </a:ext>
              </a:extLst>
            </p:cNvPr>
            <p:cNvSpPr/>
            <p:nvPr/>
          </p:nvSpPr>
          <p:spPr>
            <a:xfrm>
              <a:off x="11026720" y="2106048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DFA95070-751B-B682-4C3F-45C5EB65915F}"/>
                </a:ext>
              </a:extLst>
            </p:cNvPr>
            <p:cNvSpPr/>
            <p:nvPr/>
          </p:nvSpPr>
          <p:spPr>
            <a:xfrm>
              <a:off x="9937820" y="4234375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04334D63-DD7F-867A-D758-D142A03FCCEE}"/>
                </a:ext>
              </a:extLst>
            </p:cNvPr>
            <p:cNvSpPr/>
            <p:nvPr/>
          </p:nvSpPr>
          <p:spPr>
            <a:xfrm>
              <a:off x="8470090" y="4443003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743D3ABC-6CF4-ECA3-6617-325E2AD9DACA}"/>
                </a:ext>
              </a:extLst>
            </p:cNvPr>
            <p:cNvSpPr/>
            <p:nvPr/>
          </p:nvSpPr>
          <p:spPr>
            <a:xfrm>
              <a:off x="9203955" y="4338689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1B730F93-7D94-0D3E-CDC3-F06292FBDEA8}"/>
                </a:ext>
              </a:extLst>
            </p:cNvPr>
            <p:cNvSpPr/>
            <p:nvPr/>
          </p:nvSpPr>
          <p:spPr>
            <a:xfrm>
              <a:off x="10100601" y="184931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6C8DD7A2-CC29-C3FE-5B9E-0CB1CEF3913E}"/>
                </a:ext>
              </a:extLst>
            </p:cNvPr>
            <p:cNvSpPr/>
            <p:nvPr/>
          </p:nvSpPr>
          <p:spPr>
            <a:xfrm>
              <a:off x="10036060" y="3529563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5017C71A-1791-A0D4-E778-3784D108A8AE}"/>
                </a:ext>
              </a:extLst>
            </p:cNvPr>
            <p:cNvSpPr/>
            <p:nvPr/>
          </p:nvSpPr>
          <p:spPr>
            <a:xfrm>
              <a:off x="7292647" y="3230642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4E433B8-003E-FB2E-8A6F-7AC4CBB0AF19}"/>
              </a:ext>
            </a:extLst>
          </p:cNvPr>
          <p:cNvGrpSpPr/>
          <p:nvPr/>
        </p:nvGrpSpPr>
        <p:grpSpPr>
          <a:xfrm>
            <a:off x="0" y="51767"/>
            <a:ext cx="4097215" cy="2326793"/>
            <a:chOff x="990600" y="281586"/>
            <a:chExt cx="9215948" cy="5551196"/>
          </a:xfrm>
        </p:grpSpPr>
        <p:pic>
          <p:nvPicPr>
            <p:cNvPr id="14" name="Picture 13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C2557614-FABF-FAFE-1F22-7056C15A6BD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180009F9-290B-A8DD-38F0-F63AFED46646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11331AAF-45F4-5EA9-920A-07ED1DDD220F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2EB9C3DC-DEB1-412D-F1F2-64089E06EF58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6EA41315-0DED-20EC-080E-43B1D02FA3B5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B8B81C0F-CCE5-190C-07F5-965AE25EE207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F58675A9-AD7B-ED74-E5FD-E74BB63D5610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6103E3B0-7296-A500-1EB1-7230DF81B10F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1084894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D7FBDD9-4D76-3D2E-D01C-A78645DA40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7357" y="1463656"/>
            <a:ext cx="9139171" cy="460413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02B58FF-0F3D-E82C-71A0-E7913D6FEFF8}"/>
              </a:ext>
            </a:extLst>
          </p:cNvPr>
          <p:cNvSpPr/>
          <p:nvPr/>
        </p:nvSpPr>
        <p:spPr>
          <a:xfrm>
            <a:off x="3032170" y="6067793"/>
            <a:ext cx="891680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u: Remdesivir docked human IL-6R (1n26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F066747-2829-AC6E-6EE0-9EBEFEA8ADB8}"/>
              </a:ext>
            </a:extLst>
          </p:cNvPr>
          <p:cNvGrpSpPr/>
          <p:nvPr/>
        </p:nvGrpSpPr>
        <p:grpSpPr>
          <a:xfrm>
            <a:off x="0" y="51767"/>
            <a:ext cx="4097215" cy="2326793"/>
            <a:chOff x="990600" y="281586"/>
            <a:chExt cx="9215948" cy="5551196"/>
          </a:xfrm>
        </p:grpSpPr>
        <p:pic>
          <p:nvPicPr>
            <p:cNvPr id="5" name="Picture 4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098FB197-522A-E078-0A49-B9ABB11FC9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CE301E5F-61C8-B1A5-9660-DA3CFA77D0FF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C7426733-630F-4A8F-8809-B72637C9F243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3AB56B35-1C99-5B23-2260-63148D666E73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F30470B7-117F-6C3E-F5A9-8CFD5184ECD2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230FA66A-F7DE-EC65-B479-DC7CBFDFF231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9E889149-55A7-2798-1363-4BB37C778BA7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35D94867-D9F5-D1AB-5C24-D9F66CFCC3AD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E3D9C8E2-0EDB-A3CC-F2B1-204FF6684124}"/>
              </a:ext>
            </a:extLst>
          </p:cNvPr>
          <p:cNvSpPr/>
          <p:nvPr/>
        </p:nvSpPr>
        <p:spPr>
          <a:xfrm>
            <a:off x="11542319" y="2068306"/>
            <a:ext cx="70984" cy="53493"/>
          </a:xfrm>
          <a:prstGeom prst="star5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F1371A0E-6B16-C455-BDD5-BDFBAAFB1B07}"/>
              </a:ext>
            </a:extLst>
          </p:cNvPr>
          <p:cNvSpPr/>
          <p:nvPr/>
        </p:nvSpPr>
        <p:spPr>
          <a:xfrm>
            <a:off x="11532816" y="3765725"/>
            <a:ext cx="85058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4805E111-76AC-0F58-51D8-CC2AB47E764E}"/>
              </a:ext>
            </a:extLst>
          </p:cNvPr>
          <p:cNvSpPr/>
          <p:nvPr/>
        </p:nvSpPr>
        <p:spPr>
          <a:xfrm>
            <a:off x="11374263" y="4484433"/>
            <a:ext cx="85058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B152DCED-D30E-DE86-6471-05142CB49BCE}"/>
              </a:ext>
            </a:extLst>
          </p:cNvPr>
          <p:cNvSpPr/>
          <p:nvPr/>
        </p:nvSpPr>
        <p:spPr>
          <a:xfrm>
            <a:off x="10898696" y="4919967"/>
            <a:ext cx="85058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7FAF056E-8A2B-1621-E061-F2DB96F64938}"/>
              </a:ext>
            </a:extLst>
          </p:cNvPr>
          <p:cNvSpPr/>
          <p:nvPr/>
        </p:nvSpPr>
        <p:spPr>
          <a:xfrm>
            <a:off x="10941225" y="1903391"/>
            <a:ext cx="85058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648AB183-2860-4D78-A6A4-56E13BC41C40}"/>
              </a:ext>
            </a:extLst>
          </p:cNvPr>
          <p:cNvSpPr/>
          <p:nvPr/>
        </p:nvSpPr>
        <p:spPr>
          <a:xfrm>
            <a:off x="11354140" y="4085057"/>
            <a:ext cx="72369" cy="87447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B7C6594D-73B1-1323-82E7-06C20075A2BD}"/>
              </a:ext>
            </a:extLst>
          </p:cNvPr>
          <p:cNvSpPr/>
          <p:nvPr/>
        </p:nvSpPr>
        <p:spPr>
          <a:xfrm>
            <a:off x="10599638" y="1868749"/>
            <a:ext cx="85058" cy="69284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96536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11B17657-804B-1BB3-2DD3-A027EF81D6C1}"/>
              </a:ext>
            </a:extLst>
          </p:cNvPr>
          <p:cNvSpPr/>
          <p:nvPr/>
        </p:nvSpPr>
        <p:spPr>
          <a:xfrm>
            <a:off x="2535189" y="6066138"/>
            <a:ext cx="965681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v: Thymoquinone docked human IL-6R (1n26)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7FDD1DE-CED9-D7BF-2633-A9BE2DCC9C1F}"/>
              </a:ext>
            </a:extLst>
          </p:cNvPr>
          <p:cNvGrpSpPr/>
          <p:nvPr/>
        </p:nvGrpSpPr>
        <p:grpSpPr>
          <a:xfrm>
            <a:off x="4273061" y="572114"/>
            <a:ext cx="7778261" cy="5360411"/>
            <a:chOff x="4237892" y="442511"/>
            <a:chExt cx="7778261" cy="5360411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8EE2BE87-9726-8DA0-B8E1-859FDB3A75AE}"/>
                </a:ext>
              </a:extLst>
            </p:cNvPr>
            <p:cNvGrpSpPr/>
            <p:nvPr/>
          </p:nvGrpSpPr>
          <p:grpSpPr>
            <a:xfrm>
              <a:off x="4237892" y="442511"/>
              <a:ext cx="7778261" cy="5360411"/>
              <a:chOff x="794597" y="766391"/>
              <a:chExt cx="10602805" cy="5325218"/>
            </a:xfrm>
          </p:grpSpPr>
          <p:pic>
            <p:nvPicPr>
              <p:cNvPr id="4" name="Picture 3" descr="A close-up of a diagram&#10;&#10;Description automatically generated">
                <a:extLst>
                  <a:ext uri="{FF2B5EF4-FFF2-40B4-BE49-F238E27FC236}">
                    <a16:creationId xmlns:a16="http://schemas.microsoft.com/office/drawing/2014/main" id="{BDDC4E82-E641-C3F1-B0E8-CF1F6A5FC9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4597" y="766391"/>
                <a:ext cx="10602805" cy="5325218"/>
              </a:xfrm>
              <a:prstGeom prst="rect">
                <a:avLst/>
              </a:prstGeom>
            </p:spPr>
          </p:pic>
          <p:sp>
            <p:nvSpPr>
              <p:cNvPr id="5" name="Star: 5 Points 4">
                <a:extLst>
                  <a:ext uri="{FF2B5EF4-FFF2-40B4-BE49-F238E27FC236}">
                    <a16:creationId xmlns:a16="http://schemas.microsoft.com/office/drawing/2014/main" id="{D58F291E-5B70-B593-6C04-8E68460C6379}"/>
                  </a:ext>
                </a:extLst>
              </p:cNvPr>
              <p:cNvSpPr/>
              <p:nvPr/>
            </p:nvSpPr>
            <p:spPr>
              <a:xfrm>
                <a:off x="9040834" y="766391"/>
                <a:ext cx="162781" cy="208629"/>
              </a:xfrm>
              <a:prstGeom prst="star5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Star: 5 Points 5">
                <a:extLst>
                  <a:ext uri="{FF2B5EF4-FFF2-40B4-BE49-F238E27FC236}">
                    <a16:creationId xmlns:a16="http://schemas.microsoft.com/office/drawing/2014/main" id="{6F65B210-03EB-A872-DEE5-466B39CCA8E6}"/>
                  </a:ext>
                </a:extLst>
              </p:cNvPr>
              <p:cNvSpPr/>
              <p:nvPr/>
            </p:nvSpPr>
            <p:spPr>
              <a:xfrm>
                <a:off x="10732643" y="1866271"/>
                <a:ext cx="162781" cy="208629"/>
              </a:xfrm>
              <a:prstGeom prst="star5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Star: 5 Points 6">
                <a:extLst>
                  <a:ext uri="{FF2B5EF4-FFF2-40B4-BE49-F238E27FC236}">
                    <a16:creationId xmlns:a16="http://schemas.microsoft.com/office/drawing/2014/main" id="{94400F21-07CE-4976-ED52-F62F9C3CCC3D}"/>
                  </a:ext>
                </a:extLst>
              </p:cNvPr>
              <p:cNvSpPr/>
              <p:nvPr/>
            </p:nvSpPr>
            <p:spPr>
              <a:xfrm>
                <a:off x="9410222" y="4107765"/>
                <a:ext cx="162781" cy="208629"/>
              </a:xfrm>
              <a:prstGeom prst="star5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Star: 5 Points 7">
                <a:extLst>
                  <a:ext uri="{FF2B5EF4-FFF2-40B4-BE49-F238E27FC236}">
                    <a16:creationId xmlns:a16="http://schemas.microsoft.com/office/drawing/2014/main" id="{2FE6D7D1-F0DB-61CB-9769-04593F31B4BB}"/>
                  </a:ext>
                </a:extLst>
              </p:cNvPr>
              <p:cNvSpPr/>
              <p:nvPr/>
            </p:nvSpPr>
            <p:spPr>
              <a:xfrm>
                <a:off x="11013998" y="2893212"/>
                <a:ext cx="162781" cy="208629"/>
              </a:xfrm>
              <a:prstGeom prst="star5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Star: 5 Points 8">
                <a:extLst>
                  <a:ext uri="{FF2B5EF4-FFF2-40B4-BE49-F238E27FC236}">
                    <a16:creationId xmlns:a16="http://schemas.microsoft.com/office/drawing/2014/main" id="{22BD134F-EE29-C9AC-E7FA-84699CA407BF}"/>
                  </a:ext>
                </a:extLst>
              </p:cNvPr>
              <p:cNvSpPr/>
              <p:nvPr/>
            </p:nvSpPr>
            <p:spPr>
              <a:xfrm>
                <a:off x="7254366" y="1157175"/>
                <a:ext cx="158600" cy="168812"/>
              </a:xfrm>
              <a:prstGeom prst="star5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Star: 5 Points 1">
                <a:extLst>
                  <a:ext uri="{FF2B5EF4-FFF2-40B4-BE49-F238E27FC236}">
                    <a16:creationId xmlns:a16="http://schemas.microsoft.com/office/drawing/2014/main" id="{EB082476-9BFB-D89C-02CA-A8CB0F53581C}"/>
                  </a:ext>
                </a:extLst>
              </p:cNvPr>
              <p:cNvSpPr/>
              <p:nvPr/>
            </p:nvSpPr>
            <p:spPr>
              <a:xfrm>
                <a:off x="9508693" y="1727058"/>
                <a:ext cx="162781" cy="208629"/>
              </a:xfrm>
              <a:prstGeom prst="star5">
                <a:avLst/>
              </a:prstGeom>
              <a:solidFill>
                <a:srgbClr val="FF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Star: 5 Points 10">
                <a:extLst>
                  <a:ext uri="{FF2B5EF4-FFF2-40B4-BE49-F238E27FC236}">
                    <a16:creationId xmlns:a16="http://schemas.microsoft.com/office/drawing/2014/main" id="{B3241210-315E-D450-200C-71D631216765}"/>
                  </a:ext>
                </a:extLst>
              </p:cNvPr>
              <p:cNvSpPr/>
              <p:nvPr/>
            </p:nvSpPr>
            <p:spPr>
              <a:xfrm>
                <a:off x="7727362" y="4852211"/>
                <a:ext cx="162781" cy="208629"/>
              </a:xfrm>
              <a:prstGeom prst="star5">
                <a:avLst/>
              </a:prstGeom>
              <a:solidFill>
                <a:srgbClr val="FF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Star: 5 Points 11">
                <a:extLst>
                  <a:ext uri="{FF2B5EF4-FFF2-40B4-BE49-F238E27FC236}">
                    <a16:creationId xmlns:a16="http://schemas.microsoft.com/office/drawing/2014/main" id="{8129191E-7FE6-3925-500B-1AB999765209}"/>
                  </a:ext>
                </a:extLst>
              </p:cNvPr>
              <p:cNvSpPr/>
              <p:nvPr/>
            </p:nvSpPr>
            <p:spPr>
              <a:xfrm>
                <a:off x="10350641" y="4525023"/>
                <a:ext cx="162781" cy="208629"/>
              </a:xfrm>
              <a:prstGeom prst="star5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Star: 5 Points 12">
                <a:extLst>
                  <a:ext uri="{FF2B5EF4-FFF2-40B4-BE49-F238E27FC236}">
                    <a16:creationId xmlns:a16="http://schemas.microsoft.com/office/drawing/2014/main" id="{91264FAA-C1E8-F729-CD3C-F1B7799458BE}"/>
                  </a:ext>
                </a:extLst>
              </p:cNvPr>
              <p:cNvSpPr/>
              <p:nvPr/>
            </p:nvSpPr>
            <p:spPr>
              <a:xfrm>
                <a:off x="7890143" y="2569760"/>
                <a:ext cx="162781" cy="208629"/>
              </a:xfrm>
              <a:prstGeom prst="star5">
                <a:avLst/>
              </a:prstGeom>
              <a:solidFill>
                <a:srgbClr val="FF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Star: 5 Points 14">
                <a:extLst>
                  <a:ext uri="{FF2B5EF4-FFF2-40B4-BE49-F238E27FC236}">
                    <a16:creationId xmlns:a16="http://schemas.microsoft.com/office/drawing/2014/main" id="{D32C1752-424D-5F2C-F989-1E97F651D038}"/>
                  </a:ext>
                </a:extLst>
              </p:cNvPr>
              <p:cNvSpPr/>
              <p:nvPr/>
            </p:nvSpPr>
            <p:spPr>
              <a:xfrm>
                <a:off x="7513727" y="3384030"/>
                <a:ext cx="162781" cy="208629"/>
              </a:xfrm>
              <a:prstGeom prst="star5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795E7C43-E2FE-BDB1-1598-A5E76FBEDEF7}"/>
                </a:ext>
              </a:extLst>
            </p:cNvPr>
            <p:cNvSpPr/>
            <p:nvPr/>
          </p:nvSpPr>
          <p:spPr>
            <a:xfrm>
              <a:off x="10261586" y="3544583"/>
              <a:ext cx="162781" cy="208629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FCD6DEE-8AE1-F273-C6FD-3A1E06766916}"/>
              </a:ext>
            </a:extLst>
          </p:cNvPr>
          <p:cNvGrpSpPr/>
          <p:nvPr/>
        </p:nvGrpSpPr>
        <p:grpSpPr>
          <a:xfrm>
            <a:off x="0" y="51767"/>
            <a:ext cx="4273061" cy="2661224"/>
            <a:chOff x="990600" y="281586"/>
            <a:chExt cx="9215948" cy="5551196"/>
          </a:xfrm>
        </p:grpSpPr>
        <p:pic>
          <p:nvPicPr>
            <p:cNvPr id="20" name="Picture 19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9FEEA5C0-4834-1253-739C-4DF565FD2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56912C44-E391-77B2-7029-0E08A2AAE10B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6C6CFE8F-9A4B-2199-D6E9-00A225444680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1A22FB64-FDC5-3CA7-4B57-F2504D702E59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44BC568D-F287-6F72-0A7E-32975E409361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CEAB5E22-F2C7-214B-06AA-C2F1EE4E8C99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9B9EDD6B-9331-8027-B4F9-00A46F775175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E94F9992-A516-2E19-F611-5C6F2B120726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4402793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70A0F560-01FB-2FD4-5FFB-63550F8E348A}"/>
              </a:ext>
            </a:extLst>
          </p:cNvPr>
          <p:cNvSpPr/>
          <p:nvPr/>
        </p:nvSpPr>
        <p:spPr>
          <a:xfrm>
            <a:off x="2999483" y="6241029"/>
            <a:ext cx="919251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x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6R (1n26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5014915-E5AB-05E2-FC6C-BFCE07BDC999}"/>
              </a:ext>
            </a:extLst>
          </p:cNvPr>
          <p:cNvGrpSpPr/>
          <p:nvPr/>
        </p:nvGrpSpPr>
        <p:grpSpPr>
          <a:xfrm>
            <a:off x="4079631" y="247635"/>
            <a:ext cx="7980622" cy="5863009"/>
            <a:chOff x="823176" y="766391"/>
            <a:chExt cx="10762292" cy="5325218"/>
          </a:xfrm>
        </p:grpSpPr>
        <p:pic>
          <p:nvPicPr>
            <p:cNvPr id="6" name="Picture 5" descr="A close-up of a diagram&#10;&#10;Description automatically generated">
              <a:extLst>
                <a:ext uri="{FF2B5EF4-FFF2-40B4-BE49-F238E27FC236}">
                  <a16:creationId xmlns:a16="http://schemas.microsoft.com/office/drawing/2014/main" id="{AE158003-85E7-E5BB-7AEE-B47B8A8AE9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176" y="766391"/>
              <a:ext cx="10545647" cy="5325218"/>
            </a:xfrm>
            <a:prstGeom prst="rect">
              <a:avLst/>
            </a:prstGeom>
          </p:spPr>
        </p:pic>
        <p:sp>
          <p:nvSpPr>
            <p:cNvPr id="3" name="Arrow: Right 2">
              <a:extLst>
                <a:ext uri="{FF2B5EF4-FFF2-40B4-BE49-F238E27FC236}">
                  <a16:creationId xmlns:a16="http://schemas.microsoft.com/office/drawing/2014/main" id="{A4B9B4B1-A0F0-0D5E-1267-97693691C9F5}"/>
                </a:ext>
              </a:extLst>
            </p:cNvPr>
            <p:cNvSpPr/>
            <p:nvPr/>
          </p:nvSpPr>
          <p:spPr>
            <a:xfrm rot="9568491">
              <a:off x="11186042" y="3348772"/>
              <a:ext cx="399426" cy="329784"/>
            </a:xfrm>
            <a:prstGeom prst="right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3713DA26-C82B-A252-F0EC-C48F2A34510F}"/>
                </a:ext>
              </a:extLst>
            </p:cNvPr>
            <p:cNvSpPr/>
            <p:nvPr/>
          </p:nvSpPr>
          <p:spPr>
            <a:xfrm>
              <a:off x="8394557" y="4318782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1C18F810-FD2A-53EF-C7DA-B7AFA5F3D398}"/>
                </a:ext>
              </a:extLst>
            </p:cNvPr>
            <p:cNvSpPr/>
            <p:nvPr/>
          </p:nvSpPr>
          <p:spPr>
            <a:xfrm>
              <a:off x="10982305" y="3858172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CA6E2C83-2DE2-A9F9-1BAF-A812140AFC44}"/>
                </a:ext>
              </a:extLst>
            </p:cNvPr>
            <p:cNvSpPr/>
            <p:nvPr/>
          </p:nvSpPr>
          <p:spPr>
            <a:xfrm>
              <a:off x="9125950" y="4318782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A243CA2D-7924-5DB5-7C20-AF0F47E60327}"/>
                </a:ext>
              </a:extLst>
            </p:cNvPr>
            <p:cNvSpPr/>
            <p:nvPr/>
          </p:nvSpPr>
          <p:spPr>
            <a:xfrm>
              <a:off x="8934627" y="766391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83C6E781-849B-3CE1-1AFE-4A6648B8BA07}"/>
                </a:ext>
              </a:extLst>
            </p:cNvPr>
            <p:cNvSpPr/>
            <p:nvPr/>
          </p:nvSpPr>
          <p:spPr>
            <a:xfrm>
              <a:off x="9645827" y="4050522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C5A5D4AC-AA71-A747-B29C-B9AD376A6BED}"/>
                </a:ext>
              </a:extLst>
            </p:cNvPr>
            <p:cNvSpPr/>
            <p:nvPr/>
          </p:nvSpPr>
          <p:spPr>
            <a:xfrm>
              <a:off x="10204627" y="4627191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B8088D95-EB8D-7218-6E57-E831CC18C039}"/>
                </a:ext>
              </a:extLst>
            </p:cNvPr>
            <p:cNvSpPr/>
            <p:nvPr/>
          </p:nvSpPr>
          <p:spPr>
            <a:xfrm>
              <a:off x="7397927" y="1236486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950A9979-304E-89F4-27AB-674202BC1C77}"/>
                </a:ext>
              </a:extLst>
            </p:cNvPr>
            <p:cNvSpPr/>
            <p:nvPr/>
          </p:nvSpPr>
          <p:spPr>
            <a:xfrm>
              <a:off x="7080427" y="3858172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79B6234F-9250-2BC8-71D4-BB0D82C9F5C2}"/>
                </a:ext>
              </a:extLst>
            </p:cNvPr>
            <p:cNvSpPr/>
            <p:nvPr/>
          </p:nvSpPr>
          <p:spPr>
            <a:xfrm>
              <a:off x="7740827" y="3289216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434F68B-CF92-6050-357D-14DDA3D5A89C}"/>
              </a:ext>
            </a:extLst>
          </p:cNvPr>
          <p:cNvGrpSpPr/>
          <p:nvPr/>
        </p:nvGrpSpPr>
        <p:grpSpPr>
          <a:xfrm>
            <a:off x="65083" y="32196"/>
            <a:ext cx="4014548" cy="2517573"/>
            <a:chOff x="990600" y="281586"/>
            <a:chExt cx="9215948" cy="5551196"/>
          </a:xfrm>
        </p:grpSpPr>
        <p:pic>
          <p:nvPicPr>
            <p:cNvPr id="16" name="Picture 1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18B22C07-B279-176B-AAE5-25CC8E07EB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5D80CE29-7B3E-7436-635D-5431BC532269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644FCA6A-EFE6-8BC6-DEF2-A3C43ED112CC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367110C4-8B93-3708-522D-681C3C1EB85D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A509644E-F5D5-E55E-51FE-DAC7F6F53B07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3D7F33DB-65C5-DDE1-73E9-902EEA6DCC2C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E17F8E45-39BE-E7E3-3429-07EB8FAACAA9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D9251308-140F-E670-EAEA-10F5604BEAD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309859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0826F627-C579-722D-F953-27FACD5F41C8}"/>
              </a:ext>
            </a:extLst>
          </p:cNvPr>
          <p:cNvGrpSpPr/>
          <p:nvPr/>
        </p:nvGrpSpPr>
        <p:grpSpPr>
          <a:xfrm>
            <a:off x="2685315" y="2122553"/>
            <a:ext cx="9253770" cy="3947368"/>
            <a:chOff x="780308" y="696350"/>
            <a:chExt cx="10631384" cy="5390496"/>
          </a:xfrm>
        </p:grpSpPr>
        <p:pic>
          <p:nvPicPr>
            <p:cNvPr id="4" name="Picture 3" descr="A close-up of a diagram&#10;&#10;Description automatically generated">
              <a:extLst>
                <a:ext uri="{FF2B5EF4-FFF2-40B4-BE49-F238E27FC236}">
                  <a16:creationId xmlns:a16="http://schemas.microsoft.com/office/drawing/2014/main" id="{183E7938-1300-4982-C14D-3243764048E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0308" y="771154"/>
              <a:ext cx="10631384" cy="5315692"/>
            </a:xfrm>
            <a:prstGeom prst="rect">
              <a:avLst/>
            </a:prstGeom>
          </p:spPr>
        </p:pic>
        <p:sp>
          <p:nvSpPr>
            <p:cNvPr id="3" name="Arrow: Right 2">
              <a:extLst>
                <a:ext uri="{FF2B5EF4-FFF2-40B4-BE49-F238E27FC236}">
                  <a16:creationId xmlns:a16="http://schemas.microsoft.com/office/drawing/2014/main" id="{CEEA8294-1DE5-8ED7-5AD8-9C9F8CE19FB6}"/>
                </a:ext>
              </a:extLst>
            </p:cNvPr>
            <p:cNvSpPr/>
            <p:nvPr/>
          </p:nvSpPr>
          <p:spPr>
            <a:xfrm rot="16200000">
              <a:off x="10438463" y="4856813"/>
              <a:ext cx="399426" cy="329784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FEB248BE-CF7B-C0BD-7EED-37033E164DDB}"/>
                </a:ext>
              </a:extLst>
            </p:cNvPr>
            <p:cNvSpPr/>
            <p:nvPr/>
          </p:nvSpPr>
          <p:spPr>
            <a:xfrm>
              <a:off x="9256542" y="1378634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4C6F9A78-F73B-2F41-A395-F6BE35B4DD1A}"/>
                </a:ext>
              </a:extLst>
            </p:cNvPr>
            <p:cNvSpPr/>
            <p:nvPr/>
          </p:nvSpPr>
          <p:spPr>
            <a:xfrm>
              <a:off x="7001022" y="1756117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DCD6E338-AD1F-3F2A-9EE3-CA6B6C3DBDA8}"/>
                </a:ext>
              </a:extLst>
            </p:cNvPr>
            <p:cNvSpPr/>
            <p:nvPr/>
          </p:nvSpPr>
          <p:spPr>
            <a:xfrm>
              <a:off x="7001022" y="696350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F5D53652-F62C-7D37-5E67-DAE94CEAE184}"/>
                </a:ext>
              </a:extLst>
            </p:cNvPr>
            <p:cNvSpPr/>
            <p:nvPr/>
          </p:nvSpPr>
          <p:spPr>
            <a:xfrm>
              <a:off x="7913078" y="963637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4F58B802-C284-F6FE-00C1-6BA3BF83D472}"/>
                </a:ext>
              </a:extLst>
            </p:cNvPr>
            <p:cNvSpPr/>
            <p:nvPr/>
          </p:nvSpPr>
          <p:spPr>
            <a:xfrm>
              <a:off x="9256542" y="4203896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E25F36DB-CA8A-7638-99E0-1D08597DB98B}"/>
              </a:ext>
            </a:extLst>
          </p:cNvPr>
          <p:cNvSpPr/>
          <p:nvPr/>
        </p:nvSpPr>
        <p:spPr>
          <a:xfrm>
            <a:off x="3414186" y="6139586"/>
            <a:ext cx="852489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ca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R (1n26)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389EC65F-6C4E-A040-C1B8-3EEBD7E4CAF6}"/>
              </a:ext>
            </a:extLst>
          </p:cNvPr>
          <p:cNvGrpSpPr/>
          <p:nvPr/>
        </p:nvGrpSpPr>
        <p:grpSpPr>
          <a:xfrm>
            <a:off x="10874" y="77364"/>
            <a:ext cx="3829606" cy="2416045"/>
            <a:chOff x="990600" y="281586"/>
            <a:chExt cx="9215948" cy="5551196"/>
          </a:xfrm>
        </p:grpSpPr>
        <p:pic>
          <p:nvPicPr>
            <p:cNvPr id="20" name="Picture 19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0C6603AE-E522-65B2-0D40-634B098599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1E1712DF-DADB-4DEC-FC09-930C1C9B2FE1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229F290E-1C42-90DA-C234-98E17407ECA1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CB1DD37E-3A4B-3EBB-1C6F-BB542EF2D59B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Star: 5 Points 23">
              <a:extLst>
                <a:ext uri="{FF2B5EF4-FFF2-40B4-BE49-F238E27FC236}">
                  <a16:creationId xmlns:a16="http://schemas.microsoft.com/office/drawing/2014/main" id="{3C7707DA-0F25-4C13-1962-9943B592C8D6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D8088F90-B87B-47E9-823D-2B1145B8D033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44B4F7F8-F25F-EE5E-9755-6701CB5D3851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99472296-371A-8ADC-E150-05842B3AF9F0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6681766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tructure of a protein&#10;&#10;AI-generated content may be incorrect.">
            <a:extLst>
              <a:ext uri="{FF2B5EF4-FFF2-40B4-BE49-F238E27FC236}">
                <a16:creationId xmlns:a16="http://schemas.microsoft.com/office/drawing/2014/main" id="{73222CBB-0963-3F3B-E03C-AF0A447D3D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89" y="612966"/>
            <a:ext cx="6391557" cy="5152381"/>
          </a:xfrm>
          <a:prstGeom prst="rect">
            <a:avLst/>
          </a:prstGeom>
        </p:spPr>
      </p:pic>
      <p:pic>
        <p:nvPicPr>
          <p:cNvPr id="6" name="Picture 5" descr="A diagram of a molecule&#10;&#10;AI-generated content may be incorrect.">
            <a:extLst>
              <a:ext uri="{FF2B5EF4-FFF2-40B4-BE49-F238E27FC236}">
                <a16:creationId xmlns:a16="http://schemas.microsoft.com/office/drawing/2014/main" id="{2A2034A9-AAA3-6F7F-E391-88C9D885E7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6446" y="612966"/>
            <a:ext cx="5104762" cy="5304762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C31662D5-A21A-96B3-3CA5-FADB070A85F4}"/>
              </a:ext>
            </a:extLst>
          </p:cNvPr>
          <p:cNvSpPr/>
          <p:nvPr/>
        </p:nvSpPr>
        <p:spPr>
          <a:xfrm>
            <a:off x="1167871" y="6094615"/>
            <a:ext cx="915006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inopte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R (1n26)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6B433BE0-967B-8088-0621-6E07C74F7AB0}"/>
              </a:ext>
            </a:extLst>
          </p:cNvPr>
          <p:cNvGrpSpPr/>
          <p:nvPr/>
        </p:nvGrpSpPr>
        <p:grpSpPr>
          <a:xfrm>
            <a:off x="10874" y="77364"/>
            <a:ext cx="3829606" cy="2416045"/>
            <a:chOff x="990600" y="281586"/>
            <a:chExt cx="9215948" cy="5551196"/>
          </a:xfrm>
        </p:grpSpPr>
        <p:pic>
          <p:nvPicPr>
            <p:cNvPr id="9" name="Picture 8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BC84B2C-9A20-D35F-DE7F-6AC2B360C4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8B6056DD-D319-1CB2-F808-6D645944FDF6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1252646A-1D04-7018-60C8-AE5B5C8F88D6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C1C9ED01-E415-715C-4A48-2ABFAD8C3AA7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6312CD70-88C1-32E2-857B-A2CB95229E87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7B66B38E-0E39-392C-8A19-61ABA80C9531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D79C0D77-EF08-6227-69B8-88B15EF94431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FECC04C9-7F8A-FE86-5D0E-0F6ED3CAFF32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Star: 5 Points 1">
            <a:extLst>
              <a:ext uri="{FF2B5EF4-FFF2-40B4-BE49-F238E27FC236}">
                <a16:creationId xmlns:a16="http://schemas.microsoft.com/office/drawing/2014/main" id="{DD395FCF-D511-44E9-FB22-D17F16EACEB8}"/>
              </a:ext>
            </a:extLst>
          </p:cNvPr>
          <p:cNvSpPr/>
          <p:nvPr/>
        </p:nvSpPr>
        <p:spPr>
          <a:xfrm>
            <a:off x="9518580" y="1803836"/>
            <a:ext cx="79503" cy="71941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791AF1DE-D92A-AAF0-C9A5-330BC5BEE461}"/>
              </a:ext>
            </a:extLst>
          </p:cNvPr>
          <p:cNvSpPr/>
          <p:nvPr/>
        </p:nvSpPr>
        <p:spPr>
          <a:xfrm>
            <a:off x="9096549" y="2183664"/>
            <a:ext cx="79503" cy="71941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3FCDC659-3622-2EF8-2FD8-C9BE5B097FE9}"/>
              </a:ext>
            </a:extLst>
          </p:cNvPr>
          <p:cNvSpPr/>
          <p:nvPr/>
        </p:nvSpPr>
        <p:spPr>
          <a:xfrm>
            <a:off x="11080094" y="2858913"/>
            <a:ext cx="79503" cy="71941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93162ED9-D803-EFCE-83F6-63EA945BAFA0}"/>
              </a:ext>
            </a:extLst>
          </p:cNvPr>
          <p:cNvSpPr/>
          <p:nvPr/>
        </p:nvSpPr>
        <p:spPr>
          <a:xfrm>
            <a:off x="10672131" y="3229376"/>
            <a:ext cx="79503" cy="71941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E050E6F0-724B-C2DA-4A57-F126AC05238D}"/>
              </a:ext>
            </a:extLst>
          </p:cNvPr>
          <p:cNvSpPr/>
          <p:nvPr/>
        </p:nvSpPr>
        <p:spPr>
          <a:xfrm>
            <a:off x="9872412" y="3338198"/>
            <a:ext cx="67642" cy="90802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551A7AD6-DE1A-D967-DFDD-D897AFE0B688}"/>
              </a:ext>
            </a:extLst>
          </p:cNvPr>
          <p:cNvSpPr/>
          <p:nvPr/>
        </p:nvSpPr>
        <p:spPr>
          <a:xfrm>
            <a:off x="10683992" y="4039238"/>
            <a:ext cx="67642" cy="90802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94AFF228-44D0-F930-5621-5898B58E53A9}"/>
              </a:ext>
            </a:extLst>
          </p:cNvPr>
          <p:cNvSpPr/>
          <p:nvPr/>
        </p:nvSpPr>
        <p:spPr>
          <a:xfrm>
            <a:off x="10164395" y="1636834"/>
            <a:ext cx="67642" cy="90802"/>
          </a:xfrm>
          <a:prstGeom prst="star5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F801BDC8-8EC8-8597-584F-7F3BCEBF96C2}"/>
              </a:ext>
            </a:extLst>
          </p:cNvPr>
          <p:cNvSpPr/>
          <p:nvPr/>
        </p:nvSpPr>
        <p:spPr>
          <a:xfrm>
            <a:off x="7942676" y="4130040"/>
            <a:ext cx="67642" cy="90802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AB668D63-DE1E-0D00-E719-2216B52FE8F1}"/>
              </a:ext>
            </a:extLst>
          </p:cNvPr>
          <p:cNvSpPr/>
          <p:nvPr/>
        </p:nvSpPr>
        <p:spPr>
          <a:xfrm>
            <a:off x="8798070" y="4130040"/>
            <a:ext cx="67642" cy="90802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4062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E50F36AB-DE65-07F8-65CB-730A3C888392}"/>
              </a:ext>
            </a:extLst>
          </p:cNvPr>
          <p:cNvSpPr/>
          <p:nvPr/>
        </p:nvSpPr>
        <p:spPr>
          <a:xfrm>
            <a:off x="3115443" y="6221458"/>
            <a:ext cx="861466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c : Apigenin docked human IL-6R (1n26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4A53777-B2B8-CF1D-BD71-A06F453E8F0E}"/>
              </a:ext>
            </a:extLst>
          </p:cNvPr>
          <p:cNvGrpSpPr/>
          <p:nvPr/>
        </p:nvGrpSpPr>
        <p:grpSpPr>
          <a:xfrm>
            <a:off x="3115442" y="1566959"/>
            <a:ext cx="8614668" cy="4647729"/>
            <a:chOff x="718387" y="748323"/>
            <a:chExt cx="10755226" cy="5333759"/>
          </a:xfrm>
        </p:grpSpPr>
        <p:pic>
          <p:nvPicPr>
            <p:cNvPr id="3" name="Picture 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B604D6A3-ABFD-9308-F860-1DAA6D433D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387" y="775917"/>
              <a:ext cx="10755226" cy="5306165"/>
            </a:xfrm>
            <a:prstGeom prst="rect">
              <a:avLst/>
            </a:prstGeom>
          </p:spPr>
        </p:pic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31F9CDCD-F1E3-3A1E-51F1-69B420052C89}"/>
                </a:ext>
              </a:extLst>
            </p:cNvPr>
            <p:cNvSpPr/>
            <p:nvPr/>
          </p:nvSpPr>
          <p:spPr>
            <a:xfrm>
              <a:off x="9491708" y="7483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EA838308-F579-0495-EB23-3A09D734E600}"/>
                </a:ext>
              </a:extLst>
            </p:cNvPr>
            <p:cNvSpPr/>
            <p:nvPr/>
          </p:nvSpPr>
          <p:spPr>
            <a:xfrm>
              <a:off x="10331311" y="3530991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CFCD65E7-7F3D-9B6A-BAAF-D6212B2AB923}"/>
                </a:ext>
              </a:extLst>
            </p:cNvPr>
            <p:cNvSpPr/>
            <p:nvPr/>
          </p:nvSpPr>
          <p:spPr>
            <a:xfrm>
              <a:off x="7509803" y="861496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9FCAABA8-5757-DF73-046F-4233E25FD0AF}"/>
                </a:ext>
              </a:extLst>
            </p:cNvPr>
            <p:cNvSpPr/>
            <p:nvPr/>
          </p:nvSpPr>
          <p:spPr>
            <a:xfrm>
              <a:off x="9744926" y="2999937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1442DBA3-2727-3CBD-F12D-A3ADB158833B}"/>
                </a:ext>
              </a:extLst>
            </p:cNvPr>
            <p:cNvSpPr/>
            <p:nvPr/>
          </p:nvSpPr>
          <p:spPr>
            <a:xfrm>
              <a:off x="7143118" y="1679721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931DEB3F-51CD-F458-23F3-BA3B386970CF}"/>
                </a:ext>
              </a:extLst>
            </p:cNvPr>
            <p:cNvSpPr/>
            <p:nvPr/>
          </p:nvSpPr>
          <p:spPr>
            <a:xfrm>
              <a:off x="9854858" y="4156221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E8687C99-18CA-F5B4-8A9F-97682D6C27C6}"/>
                </a:ext>
              </a:extLst>
            </p:cNvPr>
            <p:cNvSpPr/>
            <p:nvPr/>
          </p:nvSpPr>
          <p:spPr>
            <a:xfrm>
              <a:off x="7605464" y="4364850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D147A0D9-3CF4-E5EE-E452-4CA49ABF958A}"/>
                </a:ext>
              </a:extLst>
            </p:cNvPr>
            <p:cNvSpPr/>
            <p:nvPr/>
          </p:nvSpPr>
          <p:spPr>
            <a:xfrm>
              <a:off x="10823247" y="1135142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16F58095-8F3F-9F87-E870-56B69C4BE7F4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4" name="Picture 13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95DEFE3-7E38-F7F3-7D97-09F006C61D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D02A14B6-A486-F5F1-2ED0-595A92DD7ED6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38EE7223-775C-FF9C-1B9D-AEEE5871DCC1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C45D05B8-023C-65E8-9E83-96444BDBBC7B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85968E0F-5CE9-EEF8-BB4A-3FFE6CCBE9B2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6AC0C7D2-9F4B-0C35-7714-D45E2A12207D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3A948369-D7D5-B12F-A9E0-BE16B198871E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9D5ECAE1-777E-E09B-3921-D0E3CA03A413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770922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A810B875-3D05-F9A0-F605-E41181C94329}"/>
              </a:ext>
            </a:extLst>
          </p:cNvPr>
          <p:cNvSpPr/>
          <p:nvPr/>
        </p:nvSpPr>
        <p:spPr>
          <a:xfrm>
            <a:off x="3151127" y="6167048"/>
            <a:ext cx="904087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5d : Artemisinin docked human IL-6R (1n26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6F93690-30EE-B3F5-2BF2-F288883307E7}"/>
              </a:ext>
            </a:extLst>
          </p:cNvPr>
          <p:cNvGrpSpPr/>
          <p:nvPr/>
        </p:nvGrpSpPr>
        <p:grpSpPr>
          <a:xfrm>
            <a:off x="3585883" y="1165412"/>
            <a:ext cx="8232298" cy="4997915"/>
            <a:chOff x="804124" y="766391"/>
            <a:chExt cx="10583752" cy="5325218"/>
          </a:xfrm>
        </p:grpSpPr>
        <p:pic>
          <p:nvPicPr>
            <p:cNvPr id="4" name="Picture 3" descr="A close-up of a diagram&#10;&#10;Description automatically generated">
              <a:extLst>
                <a:ext uri="{FF2B5EF4-FFF2-40B4-BE49-F238E27FC236}">
                  <a16:creationId xmlns:a16="http://schemas.microsoft.com/office/drawing/2014/main" id="{B887EE00-63FE-443D-CB11-77155FC34C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124" y="766391"/>
              <a:ext cx="10583752" cy="5325218"/>
            </a:xfrm>
            <a:prstGeom prst="rect">
              <a:avLst/>
            </a:prstGeom>
          </p:spPr>
        </p:pic>
        <p:sp>
          <p:nvSpPr>
            <p:cNvPr id="3" name="Star: 5 Points 2">
              <a:extLst>
                <a:ext uri="{FF2B5EF4-FFF2-40B4-BE49-F238E27FC236}">
                  <a16:creationId xmlns:a16="http://schemas.microsoft.com/office/drawing/2014/main" id="{C1FDC767-BBE9-A2B3-9E14-F85AC55AEDB2}"/>
                </a:ext>
              </a:extLst>
            </p:cNvPr>
            <p:cNvSpPr/>
            <p:nvPr/>
          </p:nvSpPr>
          <p:spPr>
            <a:xfrm>
              <a:off x="7329268" y="2089990"/>
              <a:ext cx="212721" cy="16084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13543A95-82DB-C4AE-9F40-C44C7C18F6F2}"/>
                </a:ext>
              </a:extLst>
            </p:cNvPr>
            <p:cNvSpPr/>
            <p:nvPr/>
          </p:nvSpPr>
          <p:spPr>
            <a:xfrm>
              <a:off x="8058443" y="872836"/>
              <a:ext cx="212721" cy="16084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45480DF3-8F76-AD87-1462-3C55EF9069E6}"/>
                </a:ext>
              </a:extLst>
            </p:cNvPr>
            <p:cNvSpPr/>
            <p:nvPr/>
          </p:nvSpPr>
          <p:spPr>
            <a:xfrm>
              <a:off x="9121356" y="4059466"/>
              <a:ext cx="212721" cy="16084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535900E0-C3EC-774A-E116-F74CB2869CE7}"/>
                </a:ext>
              </a:extLst>
            </p:cNvPr>
            <p:cNvSpPr/>
            <p:nvPr/>
          </p:nvSpPr>
          <p:spPr>
            <a:xfrm>
              <a:off x="9998275" y="1456943"/>
              <a:ext cx="212721" cy="16084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3587A586-9330-B9DF-CD96-C6ADE91B1DEB}"/>
                </a:ext>
              </a:extLst>
            </p:cNvPr>
            <p:cNvSpPr/>
            <p:nvPr/>
          </p:nvSpPr>
          <p:spPr>
            <a:xfrm>
              <a:off x="8407917" y="4420880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F32924A4-1011-F1AF-E288-E882A99F4171}"/>
                </a:ext>
              </a:extLst>
            </p:cNvPr>
            <p:cNvSpPr/>
            <p:nvPr/>
          </p:nvSpPr>
          <p:spPr>
            <a:xfrm>
              <a:off x="10648318" y="3953021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20D33BAD-E869-405D-F042-BC47C148CF06}"/>
                </a:ext>
              </a:extLst>
            </p:cNvPr>
            <p:cNvSpPr/>
            <p:nvPr/>
          </p:nvSpPr>
          <p:spPr>
            <a:xfrm>
              <a:off x="7405637" y="3210853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99C43D43-B1D9-E15A-EE03-427A8A5066E4}"/>
              </a:ext>
            </a:extLst>
          </p:cNvPr>
          <p:cNvGrpSpPr/>
          <p:nvPr/>
        </p:nvGrpSpPr>
        <p:grpSpPr>
          <a:xfrm>
            <a:off x="-34806" y="-57754"/>
            <a:ext cx="4080032" cy="2224484"/>
            <a:chOff x="990600" y="281586"/>
            <a:chExt cx="9215948" cy="5551196"/>
          </a:xfrm>
        </p:grpSpPr>
        <p:pic>
          <p:nvPicPr>
            <p:cNvPr id="16" name="Picture 1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91D093D6-023B-051E-5381-328C845C1C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24E1C3B3-C0EF-1B3A-F437-833DB2327064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A5B3C7B5-7F3F-58D9-1BA4-0E47C81641B3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12AF55AE-02C3-C8ED-9C12-74A489FA37C8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8F835156-6CD9-D52A-F397-D34DA838D5EC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32923239-FF64-607E-75C9-7D22A9A7C6FD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875F01A4-E4AF-2F95-5ABA-1B823A44D5ED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7346038D-9E5A-CD31-B800-4C5FE8ED085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672480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40EE958-D2FC-55D2-EA6C-55B9D3792636}"/>
              </a:ext>
            </a:extLst>
          </p:cNvPr>
          <p:cNvSpPr/>
          <p:nvPr/>
        </p:nvSpPr>
        <p:spPr>
          <a:xfrm>
            <a:off x="3235894" y="6174314"/>
            <a:ext cx="895610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e: Amygdalin docked human IL-6R (1n26)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D8EB1E3-2F8E-A432-13DE-BEA0F425E344}"/>
              </a:ext>
            </a:extLst>
          </p:cNvPr>
          <p:cNvGrpSpPr/>
          <p:nvPr/>
        </p:nvGrpSpPr>
        <p:grpSpPr>
          <a:xfrm>
            <a:off x="4026877" y="474785"/>
            <a:ext cx="7917475" cy="5398477"/>
            <a:chOff x="827940" y="780680"/>
            <a:chExt cx="10536120" cy="529663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D50502F-2E24-21A5-D3F7-6ED67B57A5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27940" y="780680"/>
              <a:ext cx="10536120" cy="5296639"/>
            </a:xfrm>
            <a:prstGeom prst="rect">
              <a:avLst/>
            </a:prstGeom>
          </p:spPr>
        </p:pic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03AFD512-11AC-4C8E-E725-A3E771E85119}"/>
                </a:ext>
              </a:extLst>
            </p:cNvPr>
            <p:cNvSpPr/>
            <p:nvPr/>
          </p:nvSpPr>
          <p:spPr>
            <a:xfrm>
              <a:off x="9602034" y="1430909"/>
              <a:ext cx="159665" cy="12762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5CDF599B-7B1F-1625-58FD-736E9B11CBBC}"/>
                </a:ext>
              </a:extLst>
            </p:cNvPr>
            <p:cNvSpPr/>
            <p:nvPr/>
          </p:nvSpPr>
          <p:spPr>
            <a:xfrm>
              <a:off x="8606949" y="2089821"/>
              <a:ext cx="159665" cy="12762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3F892D18-7B4C-1C62-A7A0-7B41CAC5FD4E}"/>
                </a:ext>
              </a:extLst>
            </p:cNvPr>
            <p:cNvSpPr/>
            <p:nvPr/>
          </p:nvSpPr>
          <p:spPr>
            <a:xfrm>
              <a:off x="8209739" y="1564551"/>
              <a:ext cx="159665" cy="12762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0B59607B-C9CE-129F-A2CE-31104CD3E4DB}"/>
                </a:ext>
              </a:extLst>
            </p:cNvPr>
            <p:cNvSpPr/>
            <p:nvPr/>
          </p:nvSpPr>
          <p:spPr>
            <a:xfrm>
              <a:off x="7477812" y="2089821"/>
              <a:ext cx="159665" cy="12762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D25196CF-5A3A-015C-C79B-9CBCCE67707B}"/>
                </a:ext>
              </a:extLst>
            </p:cNvPr>
            <p:cNvSpPr/>
            <p:nvPr/>
          </p:nvSpPr>
          <p:spPr>
            <a:xfrm>
              <a:off x="7238662" y="3231573"/>
              <a:ext cx="159665" cy="127622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Star: 5 Points 3">
              <a:extLst>
                <a:ext uri="{FF2B5EF4-FFF2-40B4-BE49-F238E27FC236}">
                  <a16:creationId xmlns:a16="http://schemas.microsoft.com/office/drawing/2014/main" id="{DF7144E1-0E4F-72E1-AF99-77DF7C4A3E24}"/>
                </a:ext>
              </a:extLst>
            </p:cNvPr>
            <p:cNvSpPr/>
            <p:nvPr/>
          </p:nvSpPr>
          <p:spPr>
            <a:xfrm>
              <a:off x="7682251" y="1165274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655E6261-66C4-4BFC-1B14-6462C13D4B2E}"/>
                </a:ext>
              </a:extLst>
            </p:cNvPr>
            <p:cNvSpPr/>
            <p:nvPr/>
          </p:nvSpPr>
          <p:spPr>
            <a:xfrm>
              <a:off x="9501419" y="4383753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347F598B-F710-7C32-3B91-55A2A8165BA3}"/>
                </a:ext>
              </a:extLst>
            </p:cNvPr>
            <p:cNvSpPr/>
            <p:nvPr/>
          </p:nvSpPr>
          <p:spPr>
            <a:xfrm>
              <a:off x="10183756" y="4775144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605E42EA-0D87-EE24-5810-FA3E989D1575}"/>
                </a:ext>
              </a:extLst>
            </p:cNvPr>
            <p:cNvSpPr/>
            <p:nvPr/>
          </p:nvSpPr>
          <p:spPr>
            <a:xfrm>
              <a:off x="10949220" y="3084816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C525B394-7C6D-CE04-0784-D7F423329C30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5" name="Picture 14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B3975672-4162-BC5B-BE92-9D39308027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A74B5799-76A1-3403-2907-8F8F066BCCF2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F6DD4367-E57F-7DDC-DF82-1B71632A6B6C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37890104-55B8-186F-DA09-35080814FF61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E9B4E82D-2B38-B2C9-CA22-3ED59BA5904A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A55DEF93-ED15-B3DD-2C5D-AACB08A42E97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4EA31FF4-8E9D-2EA0-6E83-EB3C4E0213F3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987AAFE9-0E1E-F5E7-49BE-CED622D6C64A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6972072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7D82FD13-BD46-1FF4-7F04-FEDC90C50D80}"/>
              </a:ext>
            </a:extLst>
          </p:cNvPr>
          <p:cNvSpPr/>
          <p:nvPr/>
        </p:nvSpPr>
        <p:spPr>
          <a:xfrm>
            <a:off x="3524250" y="6177391"/>
            <a:ext cx="864371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f : Calcitriol docked human IL-6R (1n26)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7E50B675-3F8F-0265-F1F3-F68C2021DAAC}"/>
              </a:ext>
            </a:extLst>
          </p:cNvPr>
          <p:cNvGrpSpPr/>
          <p:nvPr/>
        </p:nvGrpSpPr>
        <p:grpSpPr>
          <a:xfrm>
            <a:off x="3524250" y="1047750"/>
            <a:ext cx="7882678" cy="5048622"/>
            <a:chOff x="785071" y="761628"/>
            <a:chExt cx="10621857" cy="5334744"/>
          </a:xfrm>
        </p:grpSpPr>
        <p:pic>
          <p:nvPicPr>
            <p:cNvPr id="4" name="Picture 3" descr="A close-up of a structure&#10;&#10;Description automatically generated">
              <a:extLst>
                <a:ext uri="{FF2B5EF4-FFF2-40B4-BE49-F238E27FC236}">
                  <a16:creationId xmlns:a16="http://schemas.microsoft.com/office/drawing/2014/main" id="{A8E74CDB-6F87-C384-B46D-BBE8D255BEC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5071" y="761628"/>
              <a:ext cx="10621857" cy="5334744"/>
            </a:xfrm>
            <a:prstGeom prst="rect">
              <a:avLst/>
            </a:prstGeom>
          </p:spPr>
        </p:pic>
        <p:sp>
          <p:nvSpPr>
            <p:cNvPr id="3" name="Star: 5 Points 2">
              <a:extLst>
                <a:ext uri="{FF2B5EF4-FFF2-40B4-BE49-F238E27FC236}">
                  <a16:creationId xmlns:a16="http://schemas.microsoft.com/office/drawing/2014/main" id="{BB607A90-9082-5FEF-B4ED-BBE955F20E5D}"/>
                </a:ext>
              </a:extLst>
            </p:cNvPr>
            <p:cNvSpPr/>
            <p:nvPr/>
          </p:nvSpPr>
          <p:spPr>
            <a:xfrm>
              <a:off x="8599597" y="1959677"/>
              <a:ext cx="162781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Star: 5 Points 4">
              <a:extLst>
                <a:ext uri="{FF2B5EF4-FFF2-40B4-BE49-F238E27FC236}">
                  <a16:creationId xmlns:a16="http://schemas.microsoft.com/office/drawing/2014/main" id="{7222605E-FAC7-7960-FA89-743CA19DE94A}"/>
                </a:ext>
              </a:extLst>
            </p:cNvPr>
            <p:cNvSpPr/>
            <p:nvPr/>
          </p:nvSpPr>
          <p:spPr>
            <a:xfrm>
              <a:off x="8018585" y="4083898"/>
              <a:ext cx="162781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EF00D406-5607-0204-7F72-D950FA02195B}"/>
                </a:ext>
              </a:extLst>
            </p:cNvPr>
            <p:cNvSpPr/>
            <p:nvPr/>
          </p:nvSpPr>
          <p:spPr>
            <a:xfrm>
              <a:off x="7355059" y="2660718"/>
              <a:ext cx="162781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AE24F47F-2608-97EC-8B75-113ACC6B0F3E}"/>
                </a:ext>
              </a:extLst>
            </p:cNvPr>
            <p:cNvSpPr/>
            <p:nvPr/>
          </p:nvSpPr>
          <p:spPr>
            <a:xfrm>
              <a:off x="10164743" y="3760339"/>
              <a:ext cx="162781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360027B5-7A53-EC45-041F-B309F9631E0B}"/>
                </a:ext>
              </a:extLst>
            </p:cNvPr>
            <p:cNvSpPr/>
            <p:nvPr/>
          </p:nvSpPr>
          <p:spPr>
            <a:xfrm>
              <a:off x="10136607" y="4391045"/>
              <a:ext cx="190917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89F75586-5527-5218-827E-E0D7E914EE82}"/>
                </a:ext>
              </a:extLst>
            </p:cNvPr>
            <p:cNvSpPr/>
            <p:nvPr/>
          </p:nvSpPr>
          <p:spPr>
            <a:xfrm>
              <a:off x="10771290" y="1941342"/>
              <a:ext cx="158600" cy="168812"/>
            </a:xfrm>
            <a:prstGeom prst="star5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Star: 5 Points 1">
              <a:extLst>
                <a:ext uri="{FF2B5EF4-FFF2-40B4-BE49-F238E27FC236}">
                  <a16:creationId xmlns:a16="http://schemas.microsoft.com/office/drawing/2014/main" id="{050DA787-E5C4-CA5C-85EA-8C1DA41FA582}"/>
                </a:ext>
              </a:extLst>
            </p:cNvPr>
            <p:cNvSpPr/>
            <p:nvPr/>
          </p:nvSpPr>
          <p:spPr>
            <a:xfrm>
              <a:off x="10910109" y="3862773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2CBABE26-9A2D-EE63-69A3-493B323BFF11}"/>
                </a:ext>
              </a:extLst>
            </p:cNvPr>
            <p:cNvSpPr/>
            <p:nvPr/>
          </p:nvSpPr>
          <p:spPr>
            <a:xfrm>
              <a:off x="9144160" y="2074861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A9C82547-DF74-16BE-1D93-BB3C4CD3DA1A}"/>
                </a:ext>
              </a:extLst>
            </p:cNvPr>
            <p:cNvSpPr/>
            <p:nvPr/>
          </p:nvSpPr>
          <p:spPr>
            <a:xfrm>
              <a:off x="10292490" y="2333784"/>
              <a:ext cx="166534" cy="150477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CFEA7564-9390-DBA2-51BE-4E2555FC3CBE}"/>
              </a:ext>
            </a:extLst>
          </p:cNvPr>
          <p:cNvGrpSpPr/>
          <p:nvPr/>
        </p:nvGrpSpPr>
        <p:grpSpPr>
          <a:xfrm>
            <a:off x="0" y="51767"/>
            <a:ext cx="3756991" cy="2326793"/>
            <a:chOff x="990600" y="281586"/>
            <a:chExt cx="9215948" cy="5551196"/>
          </a:xfrm>
        </p:grpSpPr>
        <p:pic>
          <p:nvPicPr>
            <p:cNvPr id="15" name="Picture 14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D870FCA8-BBA5-1C92-F963-2388D35D23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9ACD5729-E7EC-3340-63DC-33A50D2E62C8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46D4B579-CC2C-BF7D-6E2F-F41C292A8187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E228B3A2-FFA4-45E7-3F61-835A30605F26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97482CBA-8161-B95B-CD79-661549E3D0B0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3F70D9EC-7D69-70C9-EC7C-0F2BD161C4D6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9E431F14-1F76-5929-7C1E-D957D1AAAA97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D77A3FB2-84F5-B494-9F1E-E0E4E0C9503C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364140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A099DBB-8467-3571-6C7D-889B5D4EF6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0554" y="790439"/>
            <a:ext cx="9550891" cy="527712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5DC1A78-757E-2166-8B02-99AB80FA34A9}"/>
              </a:ext>
            </a:extLst>
          </p:cNvPr>
          <p:cNvSpPr/>
          <p:nvPr/>
        </p:nvSpPr>
        <p:spPr>
          <a:xfrm>
            <a:off x="2081277" y="6135667"/>
            <a:ext cx="925445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5g: Candesartan docked human IL-6R (1n26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83D2FFD-BFD6-43DD-E61A-2D3FA461BFD7}"/>
              </a:ext>
            </a:extLst>
          </p:cNvPr>
          <p:cNvGrpSpPr/>
          <p:nvPr/>
        </p:nvGrpSpPr>
        <p:grpSpPr>
          <a:xfrm>
            <a:off x="1" y="51768"/>
            <a:ext cx="2743200" cy="1736692"/>
            <a:chOff x="990600" y="281586"/>
            <a:chExt cx="9215948" cy="5551196"/>
          </a:xfrm>
        </p:grpSpPr>
        <p:pic>
          <p:nvPicPr>
            <p:cNvPr id="6" name="Picture 5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69BBE54C-19D1-1AAB-9B13-1E9EE20819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281586"/>
              <a:ext cx="9215948" cy="5551196"/>
            </a:xfrm>
            <a:prstGeom prst="rect">
              <a:avLst/>
            </a:prstGeom>
          </p:spPr>
        </p:pic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224FF87B-B9CF-1D60-0360-078925C83EAE}"/>
                </a:ext>
              </a:extLst>
            </p:cNvPr>
            <p:cNvSpPr/>
            <p:nvPr/>
          </p:nvSpPr>
          <p:spPr>
            <a:xfrm>
              <a:off x="7211842" y="1025218"/>
              <a:ext cx="239150" cy="239151"/>
            </a:xfrm>
            <a:prstGeom prst="star5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Star: 5 Points 7">
              <a:extLst>
                <a:ext uri="{FF2B5EF4-FFF2-40B4-BE49-F238E27FC236}">
                  <a16:creationId xmlns:a16="http://schemas.microsoft.com/office/drawing/2014/main" id="{D4A313DF-28FF-D6B8-6D93-A4BF314C890D}"/>
                </a:ext>
              </a:extLst>
            </p:cNvPr>
            <p:cNvSpPr/>
            <p:nvPr/>
          </p:nvSpPr>
          <p:spPr>
            <a:xfrm>
              <a:off x="4884497" y="859923"/>
              <a:ext cx="191323" cy="165295"/>
            </a:xfrm>
            <a:prstGeom prst="star5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Star: 5 Points 8">
              <a:extLst>
                <a:ext uri="{FF2B5EF4-FFF2-40B4-BE49-F238E27FC236}">
                  <a16:creationId xmlns:a16="http://schemas.microsoft.com/office/drawing/2014/main" id="{509418D1-7C32-4275-2C8D-D05F3A66577E}"/>
                </a:ext>
              </a:extLst>
            </p:cNvPr>
            <p:cNvSpPr/>
            <p:nvPr/>
          </p:nvSpPr>
          <p:spPr>
            <a:xfrm>
              <a:off x="4359532" y="1457156"/>
              <a:ext cx="162781" cy="208629"/>
            </a:xfrm>
            <a:prstGeom prst="star5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Star: 5 Points 9">
              <a:extLst>
                <a:ext uri="{FF2B5EF4-FFF2-40B4-BE49-F238E27FC236}">
                  <a16:creationId xmlns:a16="http://schemas.microsoft.com/office/drawing/2014/main" id="{C0B18FC1-3F33-DC87-8F74-C7CEE8108167}"/>
                </a:ext>
              </a:extLst>
            </p:cNvPr>
            <p:cNvSpPr/>
            <p:nvPr/>
          </p:nvSpPr>
          <p:spPr>
            <a:xfrm>
              <a:off x="3801845" y="1438421"/>
              <a:ext cx="162781" cy="208629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80CF1FE9-9924-6B49-B90F-2BF7EC29DF45}"/>
                </a:ext>
              </a:extLst>
            </p:cNvPr>
            <p:cNvSpPr/>
            <p:nvPr/>
          </p:nvSpPr>
          <p:spPr>
            <a:xfrm>
              <a:off x="5904677" y="1561470"/>
              <a:ext cx="191323" cy="165295"/>
            </a:xfrm>
            <a:prstGeom prst="star5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EEB87D45-1512-5EE8-EF85-DFFE37392DF0}"/>
                </a:ext>
              </a:extLst>
            </p:cNvPr>
            <p:cNvSpPr/>
            <p:nvPr/>
          </p:nvSpPr>
          <p:spPr>
            <a:xfrm>
              <a:off x="7812401" y="1881401"/>
              <a:ext cx="158600" cy="168812"/>
            </a:xfrm>
            <a:prstGeom prst="star5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9D6245D5-13F5-1AAF-6E8E-266F5BF08469}"/>
                </a:ext>
              </a:extLst>
            </p:cNvPr>
            <p:cNvSpPr/>
            <p:nvPr/>
          </p:nvSpPr>
          <p:spPr>
            <a:xfrm>
              <a:off x="3269207" y="1395392"/>
              <a:ext cx="159665" cy="127622"/>
            </a:xfrm>
            <a:prstGeom prst="star5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9C1001C4-9E63-D868-94F2-BC05A621808C}"/>
              </a:ext>
            </a:extLst>
          </p:cNvPr>
          <p:cNvSpPr/>
          <p:nvPr/>
        </p:nvSpPr>
        <p:spPr>
          <a:xfrm>
            <a:off x="8750912" y="890597"/>
            <a:ext cx="118211" cy="11851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76C7357B-8B6E-711D-2D55-02F0062F3F7A}"/>
              </a:ext>
            </a:extLst>
          </p:cNvPr>
          <p:cNvSpPr/>
          <p:nvPr/>
        </p:nvSpPr>
        <p:spPr>
          <a:xfrm>
            <a:off x="9293056" y="1009107"/>
            <a:ext cx="118211" cy="11851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04CBAACA-1D6E-C2A8-565D-A6D3AFE21490}"/>
              </a:ext>
            </a:extLst>
          </p:cNvPr>
          <p:cNvSpPr/>
          <p:nvPr/>
        </p:nvSpPr>
        <p:spPr>
          <a:xfrm>
            <a:off x="9964039" y="1068362"/>
            <a:ext cx="118211" cy="11851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0CE7B7D2-384A-EA4F-326B-7C40C1A0794A}"/>
              </a:ext>
            </a:extLst>
          </p:cNvPr>
          <p:cNvSpPr/>
          <p:nvPr/>
        </p:nvSpPr>
        <p:spPr>
          <a:xfrm>
            <a:off x="10328313" y="2915748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758FB3F8-697C-5B56-2190-5ED124077918}"/>
              </a:ext>
            </a:extLst>
          </p:cNvPr>
          <p:cNvSpPr/>
          <p:nvPr/>
        </p:nvSpPr>
        <p:spPr>
          <a:xfrm>
            <a:off x="8003896" y="2307493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05E85316-F9F4-3AD9-A56F-F0F23813721F}"/>
              </a:ext>
            </a:extLst>
          </p:cNvPr>
          <p:cNvSpPr/>
          <p:nvPr/>
        </p:nvSpPr>
        <p:spPr>
          <a:xfrm>
            <a:off x="8571059" y="4617732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2A452D87-F4C2-269C-0EC2-E04B8A8DA4E3}"/>
              </a:ext>
            </a:extLst>
          </p:cNvPr>
          <p:cNvSpPr/>
          <p:nvPr/>
        </p:nvSpPr>
        <p:spPr>
          <a:xfrm>
            <a:off x="9759600" y="4499222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C4A00060-D9A2-3C1A-7ECA-F8F0F00BB94F}"/>
              </a:ext>
            </a:extLst>
          </p:cNvPr>
          <p:cNvSpPr/>
          <p:nvPr/>
        </p:nvSpPr>
        <p:spPr>
          <a:xfrm>
            <a:off x="8063880" y="2676829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D5C8C485-AB43-5DF9-26E9-8FF618365EAE}"/>
              </a:ext>
            </a:extLst>
          </p:cNvPr>
          <p:cNvSpPr/>
          <p:nvPr/>
        </p:nvSpPr>
        <p:spPr>
          <a:xfrm>
            <a:off x="7945669" y="1938158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BCD103D5-DBD6-A86B-2B2E-FD8B8ED2C750}"/>
              </a:ext>
            </a:extLst>
          </p:cNvPr>
          <p:cNvSpPr/>
          <p:nvPr/>
        </p:nvSpPr>
        <p:spPr>
          <a:xfrm>
            <a:off x="1283750" y="103040"/>
            <a:ext cx="118211" cy="118510"/>
          </a:xfrm>
          <a:prstGeom prst="star5">
            <a:avLst/>
          </a:prstGeom>
          <a:solidFill>
            <a:srgbClr val="FFFF00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191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6</TotalTime>
  <Words>465</Words>
  <Application>Microsoft Office PowerPoint</Application>
  <PresentationFormat>Widescreen</PresentationFormat>
  <Paragraphs>27</Paragraphs>
  <Slides>2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64</cp:revision>
  <dcterms:created xsi:type="dcterms:W3CDTF">2024-11-17T09:26:34Z</dcterms:created>
  <dcterms:modified xsi:type="dcterms:W3CDTF">2025-09-16T16:32:46Z</dcterms:modified>
</cp:coreProperties>
</file>